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7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79A95D-F076-4AB9-AEC1-B99983806C2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816750-4B8C-4779-A760-B09F632423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59389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4816750-4B8C-4779-A760-B09F6324231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26119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BEF614-E78D-C0B8-A730-F86AA7C178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6B1CF93-1D48-2F27-3F35-BCD5D3CBEE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B827E4-22B9-72E1-3924-E699B9452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E7A9D5-FCCB-BBE3-CEBF-1899BC809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370AF6-DFBF-9E75-1AFF-53EB38E2D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7953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029AB5-3834-8D29-C19A-F8FD3EC596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74D8DB7-68D9-788E-7D45-10EA3D4C8F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B09205-939E-C5A3-E701-C2A29AC67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4C913F-E631-64A8-F3C0-AA8808AB1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C7FAE2-2092-F13E-32D0-D5E154C8F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9847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D754A5D-7216-3CAD-D150-6925F54926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66DDEF-D261-9319-FF0D-ECC4867AB8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000CA2-3F8C-FBE4-D9B9-77B0E7B0A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66C1ED-89B3-57D7-22EC-F7C0DEFC0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5C3863-1526-E1A6-93A1-8018E5A25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295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FA52FA-2EFE-ADDD-BA42-D46AA72CB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56E7EE-C308-0E0F-2A2D-9B5B3AF5C7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1BC9D4-B437-16BB-86D7-F22C65143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BC3188-93EA-3AD7-CE25-F4D5504BC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8AB236-673F-0E2D-25C3-481E895CD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1564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A46262-F3F5-D376-346C-A5DA6873F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6E98D41-F6DD-657C-D2F5-E4E7AF72EF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623505-12A7-6C74-6507-D326B0FE0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F18610-0D18-36F3-AB8F-D63D0C7AC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CFAEEE-33A5-2787-892F-FFC70CA956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060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3DE35B-58F4-D8DF-E6FF-1A0A82CCDC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7ED431-1A07-7D3B-6562-1A9877A438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52F1BB5-203F-65DF-0E4D-BC36394C5B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375C32-F3C4-FE7D-47DA-A9D23AB55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ACA8E68-23D6-4FBB-7389-39EF94D13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2406CC-3F35-D7E6-55F7-0D93F3C9B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4667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015207-7932-8073-9346-E3B3E7062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2C60EE5-F299-8D50-CF18-3C3AEFE5B5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9E8B3A7-3615-C7CC-2165-8F2C7F0F37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2984A36-A048-0B83-293A-89166D9DC1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AB7B9F0-BBBE-AE04-EAB6-72630E4DD5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07CE5CB-F5E1-322D-309C-3A8BC5D16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33795A7-7942-25EA-AE69-12626A7085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80AA376-D06F-AA6D-3930-0E0313503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2842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211CA8-C1E7-5829-DE30-E55BB8C4CB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B19B6EF-5622-9CAA-99AF-EC8A2A5D12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8D09993-9522-4DC3-90CA-B0A8A63EE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B20A1CD-B8DC-5FC5-E52A-6DEDA56E6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0054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01E3997-9F71-3761-C0E0-081A580C0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EF186CA-F544-003B-9057-ED22C6EA9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7BB4E28-F1D2-610B-8438-5252A5F87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7688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A79208-B555-D5EE-8EA0-B32D17FBD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9526BDD-61AE-D933-6468-42F34EE0B9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5FF1254-8ADD-CCB8-8D32-D1EAA8F1A1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8C8F34F-8ED8-BC50-A204-CE656553B5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382E45-7C64-1DF5-D48C-F51045B78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1D4F804-E856-888E-B17E-5B16F320B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5777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1AAC52-68EE-3093-9B05-9EF2E67E93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9D8D450-8713-30D8-14CD-ED812F4BCD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7E1AB4C-680C-89CA-F6BB-D4C0D62B7A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527CE9B-3477-39D6-6D48-C1F0C1F3C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5BE8CA4-27E7-A196-F2E5-BAAA3652A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84EA8B3-DFE9-F813-B54D-4A42F8D21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8652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3895B36-BC2F-BB9A-2A99-53717620B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081D80D-D670-4D32-37C8-7C4E547FC1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103A1A-BBBC-BDD1-C1F7-72B2F575CF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08C7BB-D4EE-4E68-BB71-A7E14B308F68}" type="datetimeFigureOut">
              <a:rPr lang="zh-CN" altLang="en-US" smtClean="0"/>
              <a:t>2022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77260E4-8ADF-561F-C1EB-EE000B05CF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A7E1FB-89D1-C87A-24D2-3CF1C13D52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18B653-2B19-47DA-BC2A-C2116B8A71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1101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0" name="组合 99">
            <a:extLst>
              <a:ext uri="{FF2B5EF4-FFF2-40B4-BE49-F238E27FC236}">
                <a16:creationId xmlns:a16="http://schemas.microsoft.com/office/drawing/2014/main" id="{F7098467-B144-8212-BDCB-7AC4A424235E}"/>
              </a:ext>
            </a:extLst>
          </p:cNvPr>
          <p:cNvGrpSpPr/>
          <p:nvPr/>
        </p:nvGrpSpPr>
        <p:grpSpPr>
          <a:xfrm>
            <a:off x="4052712" y="1162756"/>
            <a:ext cx="4470400" cy="3917244"/>
            <a:chOff x="4052711" y="1162756"/>
            <a:chExt cx="4718755" cy="4120444"/>
          </a:xfrm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</p:grpSpPr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0AB0B70D-6297-A768-0CA8-04080B5BBCDB}"/>
                </a:ext>
              </a:extLst>
            </p:cNvPr>
            <p:cNvSpPr/>
            <p:nvPr/>
          </p:nvSpPr>
          <p:spPr>
            <a:xfrm>
              <a:off x="4052711" y="1162756"/>
              <a:ext cx="936978" cy="4120444"/>
            </a:xfrm>
            <a:prstGeom prst="rect">
              <a:avLst/>
            </a:prstGeom>
            <a:noFill/>
            <a:ln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85203968-6D5D-08F0-8499-0ACB2F8ED269}"/>
                </a:ext>
              </a:extLst>
            </p:cNvPr>
            <p:cNvGrpSpPr/>
            <p:nvPr/>
          </p:nvGrpSpPr>
          <p:grpSpPr>
            <a:xfrm>
              <a:off x="4185356" y="1354666"/>
              <a:ext cx="443089" cy="440267"/>
              <a:chOff x="3060700" y="3048000"/>
              <a:chExt cx="762000" cy="762000"/>
            </a:xfrm>
          </p:grpSpPr>
          <p:sp>
            <p:nvSpPr>
              <p:cNvPr id="7" name="Oval 19">
                <a:extLst>
                  <a:ext uri="{FF2B5EF4-FFF2-40B4-BE49-F238E27FC236}">
                    <a16:creationId xmlns:a16="http://schemas.microsoft.com/office/drawing/2014/main" id="{9D9C9783-F15D-1FBF-D9A0-FDBB79F420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0700" y="30480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Freeform 87">
                <a:extLst>
                  <a:ext uri="{FF2B5EF4-FFF2-40B4-BE49-F238E27FC236}">
                    <a16:creationId xmlns:a16="http://schemas.microsoft.com/office/drawing/2014/main" id="{DE3828C3-8243-08AD-6651-1D8E6223B59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222625" y="3184525"/>
                <a:ext cx="419100" cy="469900"/>
              </a:xfrm>
              <a:custGeom>
                <a:avLst/>
                <a:gdLst>
                  <a:gd name="T0" fmla="*/ 97 w 132"/>
                  <a:gd name="T1" fmla="*/ 107 h 148"/>
                  <a:gd name="T2" fmla="*/ 19 w 132"/>
                  <a:gd name="T3" fmla="*/ 98 h 148"/>
                  <a:gd name="T4" fmla="*/ 29 w 132"/>
                  <a:gd name="T5" fmla="*/ 19 h 148"/>
                  <a:gd name="T6" fmla="*/ 107 w 132"/>
                  <a:gd name="T7" fmla="*/ 29 h 148"/>
                  <a:gd name="T8" fmla="*/ 97 w 132"/>
                  <a:gd name="T9" fmla="*/ 107 h 148"/>
                  <a:gd name="T10" fmla="*/ 97 w 132"/>
                  <a:gd name="T11" fmla="*/ 36 h 148"/>
                  <a:gd name="T12" fmla="*/ 36 w 132"/>
                  <a:gd name="T13" fmla="*/ 29 h 148"/>
                  <a:gd name="T14" fmla="*/ 29 w 132"/>
                  <a:gd name="T15" fmla="*/ 90 h 148"/>
                  <a:gd name="T16" fmla="*/ 90 w 132"/>
                  <a:gd name="T17" fmla="*/ 98 h 148"/>
                  <a:gd name="T18" fmla="*/ 97 w 132"/>
                  <a:gd name="T19" fmla="*/ 36 h 148"/>
                  <a:gd name="T20" fmla="*/ 97 w 132"/>
                  <a:gd name="T21" fmla="*/ 111 h 148"/>
                  <a:gd name="T22" fmla="*/ 101 w 132"/>
                  <a:gd name="T23" fmla="*/ 108 h 148"/>
                  <a:gd name="T24" fmla="*/ 110 w 132"/>
                  <a:gd name="T25" fmla="*/ 109 h 148"/>
                  <a:gd name="T26" fmla="*/ 119 w 132"/>
                  <a:gd name="T27" fmla="*/ 121 h 148"/>
                  <a:gd name="T28" fmla="*/ 106 w 132"/>
                  <a:gd name="T29" fmla="*/ 132 h 148"/>
                  <a:gd name="T30" fmla="*/ 96 w 132"/>
                  <a:gd name="T31" fmla="*/ 120 h 148"/>
                  <a:gd name="T32" fmla="*/ 97 w 132"/>
                  <a:gd name="T33" fmla="*/ 111 h 148"/>
                  <a:gd name="T34" fmla="*/ 128 w 132"/>
                  <a:gd name="T35" fmla="*/ 143 h 148"/>
                  <a:gd name="T36" fmla="*/ 125 w 132"/>
                  <a:gd name="T37" fmla="*/ 146 h 148"/>
                  <a:gd name="T38" fmla="*/ 116 w 132"/>
                  <a:gd name="T39" fmla="*/ 145 h 148"/>
                  <a:gd name="T40" fmla="*/ 110 w 132"/>
                  <a:gd name="T41" fmla="*/ 137 h 148"/>
                  <a:gd name="T42" fmla="*/ 123 w 132"/>
                  <a:gd name="T43" fmla="*/ 126 h 148"/>
                  <a:gd name="T44" fmla="*/ 130 w 132"/>
                  <a:gd name="T45" fmla="*/ 134 h 148"/>
                  <a:gd name="T46" fmla="*/ 128 w 132"/>
                  <a:gd name="T47" fmla="*/ 143 h 148"/>
                  <a:gd name="T48" fmla="*/ 92 w 132"/>
                  <a:gd name="T49" fmla="*/ 50 h 148"/>
                  <a:gd name="T50" fmla="*/ 91 w 132"/>
                  <a:gd name="T51" fmla="*/ 50 h 148"/>
                  <a:gd name="T52" fmla="*/ 87 w 132"/>
                  <a:gd name="T53" fmla="*/ 48 h 148"/>
                  <a:gd name="T54" fmla="*/ 77 w 132"/>
                  <a:gd name="T55" fmla="*/ 37 h 148"/>
                  <a:gd name="T56" fmla="*/ 67 w 132"/>
                  <a:gd name="T57" fmla="*/ 36 h 148"/>
                  <a:gd name="T58" fmla="*/ 65 w 132"/>
                  <a:gd name="T59" fmla="*/ 36 h 148"/>
                  <a:gd name="T60" fmla="*/ 65 w 132"/>
                  <a:gd name="T61" fmla="*/ 36 h 148"/>
                  <a:gd name="T62" fmla="*/ 65 w 132"/>
                  <a:gd name="T63" fmla="*/ 36 h 148"/>
                  <a:gd name="T64" fmla="*/ 61 w 132"/>
                  <a:gd name="T65" fmla="*/ 33 h 148"/>
                  <a:gd name="T66" fmla="*/ 64 w 132"/>
                  <a:gd name="T67" fmla="*/ 29 h 148"/>
                  <a:gd name="T68" fmla="*/ 66 w 132"/>
                  <a:gd name="T69" fmla="*/ 28 h 148"/>
                  <a:gd name="T70" fmla="*/ 79 w 132"/>
                  <a:gd name="T71" fmla="*/ 30 h 148"/>
                  <a:gd name="T72" fmla="*/ 94 w 132"/>
                  <a:gd name="T73" fmla="*/ 45 h 148"/>
                  <a:gd name="T74" fmla="*/ 92 w 132"/>
                  <a:gd name="T75" fmla="*/ 50 h 148"/>
                  <a:gd name="T76" fmla="*/ 89 w 132"/>
                  <a:gd name="T77" fmla="*/ 58 h 148"/>
                  <a:gd name="T78" fmla="*/ 92 w 132"/>
                  <a:gd name="T79" fmla="*/ 53 h 148"/>
                  <a:gd name="T80" fmla="*/ 96 w 132"/>
                  <a:gd name="T81" fmla="*/ 57 h 148"/>
                  <a:gd name="T82" fmla="*/ 93 w 132"/>
                  <a:gd name="T83" fmla="*/ 61 h 148"/>
                  <a:gd name="T84" fmla="*/ 89 w 132"/>
                  <a:gd name="T85" fmla="*/ 5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</a:cxnLst>
                <a:rect l="0" t="0" r="r" b="b"/>
                <a:pathLst>
                  <a:path w="132" h="148">
                    <a:moveTo>
                      <a:pt x="97" y="107"/>
                    </a:moveTo>
                    <a:cubicBezTo>
                      <a:pt x="73" y="126"/>
                      <a:pt x="38" y="122"/>
                      <a:pt x="19" y="98"/>
                    </a:cubicBezTo>
                    <a:cubicBezTo>
                      <a:pt x="0" y="73"/>
                      <a:pt x="4" y="38"/>
                      <a:pt x="29" y="19"/>
                    </a:cubicBezTo>
                    <a:cubicBezTo>
                      <a:pt x="53" y="0"/>
                      <a:pt x="88" y="5"/>
                      <a:pt x="107" y="29"/>
                    </a:cubicBezTo>
                    <a:cubicBezTo>
                      <a:pt x="126" y="53"/>
                      <a:pt x="122" y="88"/>
                      <a:pt x="97" y="107"/>
                    </a:cubicBezTo>
                    <a:close/>
                    <a:moveTo>
                      <a:pt x="97" y="36"/>
                    </a:moveTo>
                    <a:cubicBezTo>
                      <a:pt x="83" y="17"/>
                      <a:pt x="55" y="14"/>
                      <a:pt x="36" y="29"/>
                    </a:cubicBezTo>
                    <a:cubicBezTo>
                      <a:pt x="17" y="44"/>
                      <a:pt x="14" y="71"/>
                      <a:pt x="29" y="90"/>
                    </a:cubicBezTo>
                    <a:cubicBezTo>
                      <a:pt x="43" y="109"/>
                      <a:pt x="71" y="112"/>
                      <a:pt x="90" y="98"/>
                    </a:cubicBezTo>
                    <a:cubicBezTo>
                      <a:pt x="109" y="83"/>
                      <a:pt x="112" y="55"/>
                      <a:pt x="97" y="36"/>
                    </a:cubicBezTo>
                    <a:close/>
                    <a:moveTo>
                      <a:pt x="97" y="111"/>
                    </a:moveTo>
                    <a:cubicBezTo>
                      <a:pt x="101" y="108"/>
                      <a:pt x="101" y="108"/>
                      <a:pt x="101" y="108"/>
                    </a:cubicBezTo>
                    <a:cubicBezTo>
                      <a:pt x="104" y="106"/>
                      <a:pt x="108" y="106"/>
                      <a:pt x="110" y="109"/>
                    </a:cubicBezTo>
                    <a:cubicBezTo>
                      <a:pt x="119" y="121"/>
                      <a:pt x="119" y="121"/>
                      <a:pt x="119" y="121"/>
                    </a:cubicBezTo>
                    <a:cubicBezTo>
                      <a:pt x="106" y="132"/>
                      <a:pt x="106" y="132"/>
                      <a:pt x="106" y="132"/>
                    </a:cubicBezTo>
                    <a:cubicBezTo>
                      <a:pt x="96" y="120"/>
                      <a:pt x="96" y="120"/>
                      <a:pt x="96" y="120"/>
                    </a:cubicBezTo>
                    <a:cubicBezTo>
                      <a:pt x="94" y="117"/>
                      <a:pt x="95" y="113"/>
                      <a:pt x="97" y="111"/>
                    </a:cubicBezTo>
                    <a:close/>
                    <a:moveTo>
                      <a:pt x="128" y="143"/>
                    </a:moveTo>
                    <a:cubicBezTo>
                      <a:pt x="125" y="146"/>
                      <a:pt x="125" y="146"/>
                      <a:pt x="125" y="146"/>
                    </a:cubicBezTo>
                    <a:cubicBezTo>
                      <a:pt x="122" y="148"/>
                      <a:pt x="118" y="148"/>
                      <a:pt x="116" y="145"/>
                    </a:cubicBezTo>
                    <a:cubicBezTo>
                      <a:pt x="110" y="137"/>
                      <a:pt x="110" y="137"/>
                      <a:pt x="110" y="137"/>
                    </a:cubicBezTo>
                    <a:cubicBezTo>
                      <a:pt x="123" y="126"/>
                      <a:pt x="123" y="126"/>
                      <a:pt x="123" y="126"/>
                    </a:cubicBezTo>
                    <a:cubicBezTo>
                      <a:pt x="130" y="134"/>
                      <a:pt x="130" y="134"/>
                      <a:pt x="130" y="134"/>
                    </a:cubicBezTo>
                    <a:cubicBezTo>
                      <a:pt x="132" y="137"/>
                      <a:pt x="131" y="141"/>
                      <a:pt x="128" y="143"/>
                    </a:cubicBezTo>
                    <a:close/>
                    <a:moveTo>
                      <a:pt x="92" y="50"/>
                    </a:moveTo>
                    <a:cubicBezTo>
                      <a:pt x="91" y="50"/>
                      <a:pt x="91" y="50"/>
                      <a:pt x="91" y="50"/>
                    </a:cubicBezTo>
                    <a:cubicBezTo>
                      <a:pt x="89" y="50"/>
                      <a:pt x="88" y="49"/>
                      <a:pt x="87" y="48"/>
                    </a:cubicBezTo>
                    <a:cubicBezTo>
                      <a:pt x="84" y="41"/>
                      <a:pt x="81" y="38"/>
                      <a:pt x="77" y="37"/>
                    </a:cubicBezTo>
                    <a:cubicBezTo>
                      <a:pt x="73" y="35"/>
                      <a:pt x="69" y="35"/>
                      <a:pt x="67" y="36"/>
                    </a:cubicBezTo>
                    <a:cubicBezTo>
                      <a:pt x="66" y="36"/>
                      <a:pt x="66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3" y="36"/>
                      <a:pt x="61" y="35"/>
                      <a:pt x="61" y="33"/>
                    </a:cubicBezTo>
                    <a:cubicBezTo>
                      <a:pt x="60" y="31"/>
                      <a:pt x="62" y="29"/>
                      <a:pt x="64" y="29"/>
                    </a:cubicBezTo>
                    <a:cubicBezTo>
                      <a:pt x="64" y="29"/>
                      <a:pt x="65" y="28"/>
                      <a:pt x="66" y="28"/>
                    </a:cubicBezTo>
                    <a:cubicBezTo>
                      <a:pt x="69" y="28"/>
                      <a:pt x="74" y="28"/>
                      <a:pt x="79" y="30"/>
                    </a:cubicBezTo>
                    <a:cubicBezTo>
                      <a:pt x="85" y="32"/>
                      <a:pt x="90" y="37"/>
                      <a:pt x="94" y="45"/>
                    </a:cubicBezTo>
                    <a:cubicBezTo>
                      <a:pt x="95" y="47"/>
                      <a:pt x="94" y="49"/>
                      <a:pt x="92" y="50"/>
                    </a:cubicBezTo>
                    <a:close/>
                    <a:moveTo>
                      <a:pt x="89" y="58"/>
                    </a:moveTo>
                    <a:cubicBezTo>
                      <a:pt x="88" y="55"/>
                      <a:pt x="90" y="54"/>
                      <a:pt x="92" y="53"/>
                    </a:cubicBezTo>
                    <a:cubicBezTo>
                      <a:pt x="94" y="53"/>
                      <a:pt x="96" y="55"/>
                      <a:pt x="96" y="57"/>
                    </a:cubicBezTo>
                    <a:cubicBezTo>
                      <a:pt x="97" y="59"/>
                      <a:pt x="95" y="61"/>
                      <a:pt x="93" y="61"/>
                    </a:cubicBezTo>
                    <a:cubicBezTo>
                      <a:pt x="91" y="61"/>
                      <a:pt x="89" y="60"/>
                      <a:pt x="89" y="58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996DF57D-9C72-1185-EBB7-21BF964BA35B}"/>
                </a:ext>
              </a:extLst>
            </p:cNvPr>
            <p:cNvGrpSpPr/>
            <p:nvPr/>
          </p:nvGrpSpPr>
          <p:grpSpPr>
            <a:xfrm>
              <a:off x="4185356" y="2088936"/>
              <a:ext cx="443089" cy="440267"/>
              <a:chOff x="3060700" y="3048000"/>
              <a:chExt cx="762000" cy="762000"/>
            </a:xfrm>
          </p:grpSpPr>
          <p:sp>
            <p:nvSpPr>
              <p:cNvPr id="10" name="Oval 19">
                <a:extLst>
                  <a:ext uri="{FF2B5EF4-FFF2-40B4-BE49-F238E27FC236}">
                    <a16:creationId xmlns:a16="http://schemas.microsoft.com/office/drawing/2014/main" id="{D5D721AD-8B4F-C09A-F234-177C9259C2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0700" y="30480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Freeform 87">
                <a:extLst>
                  <a:ext uri="{FF2B5EF4-FFF2-40B4-BE49-F238E27FC236}">
                    <a16:creationId xmlns:a16="http://schemas.microsoft.com/office/drawing/2014/main" id="{F87D7E3C-9774-BE3C-E322-C6DB1E71A90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222625" y="3184525"/>
                <a:ext cx="419100" cy="469900"/>
              </a:xfrm>
              <a:custGeom>
                <a:avLst/>
                <a:gdLst>
                  <a:gd name="T0" fmla="*/ 97 w 132"/>
                  <a:gd name="T1" fmla="*/ 107 h 148"/>
                  <a:gd name="T2" fmla="*/ 19 w 132"/>
                  <a:gd name="T3" fmla="*/ 98 h 148"/>
                  <a:gd name="T4" fmla="*/ 29 w 132"/>
                  <a:gd name="T5" fmla="*/ 19 h 148"/>
                  <a:gd name="T6" fmla="*/ 107 w 132"/>
                  <a:gd name="T7" fmla="*/ 29 h 148"/>
                  <a:gd name="T8" fmla="*/ 97 w 132"/>
                  <a:gd name="T9" fmla="*/ 107 h 148"/>
                  <a:gd name="T10" fmla="*/ 97 w 132"/>
                  <a:gd name="T11" fmla="*/ 36 h 148"/>
                  <a:gd name="T12" fmla="*/ 36 w 132"/>
                  <a:gd name="T13" fmla="*/ 29 h 148"/>
                  <a:gd name="T14" fmla="*/ 29 w 132"/>
                  <a:gd name="T15" fmla="*/ 90 h 148"/>
                  <a:gd name="T16" fmla="*/ 90 w 132"/>
                  <a:gd name="T17" fmla="*/ 98 h 148"/>
                  <a:gd name="T18" fmla="*/ 97 w 132"/>
                  <a:gd name="T19" fmla="*/ 36 h 148"/>
                  <a:gd name="T20" fmla="*/ 97 w 132"/>
                  <a:gd name="T21" fmla="*/ 111 h 148"/>
                  <a:gd name="T22" fmla="*/ 101 w 132"/>
                  <a:gd name="T23" fmla="*/ 108 h 148"/>
                  <a:gd name="T24" fmla="*/ 110 w 132"/>
                  <a:gd name="T25" fmla="*/ 109 h 148"/>
                  <a:gd name="T26" fmla="*/ 119 w 132"/>
                  <a:gd name="T27" fmla="*/ 121 h 148"/>
                  <a:gd name="T28" fmla="*/ 106 w 132"/>
                  <a:gd name="T29" fmla="*/ 132 h 148"/>
                  <a:gd name="T30" fmla="*/ 96 w 132"/>
                  <a:gd name="T31" fmla="*/ 120 h 148"/>
                  <a:gd name="T32" fmla="*/ 97 w 132"/>
                  <a:gd name="T33" fmla="*/ 111 h 148"/>
                  <a:gd name="T34" fmla="*/ 128 w 132"/>
                  <a:gd name="T35" fmla="*/ 143 h 148"/>
                  <a:gd name="T36" fmla="*/ 125 w 132"/>
                  <a:gd name="T37" fmla="*/ 146 h 148"/>
                  <a:gd name="T38" fmla="*/ 116 w 132"/>
                  <a:gd name="T39" fmla="*/ 145 h 148"/>
                  <a:gd name="T40" fmla="*/ 110 w 132"/>
                  <a:gd name="T41" fmla="*/ 137 h 148"/>
                  <a:gd name="T42" fmla="*/ 123 w 132"/>
                  <a:gd name="T43" fmla="*/ 126 h 148"/>
                  <a:gd name="T44" fmla="*/ 130 w 132"/>
                  <a:gd name="T45" fmla="*/ 134 h 148"/>
                  <a:gd name="T46" fmla="*/ 128 w 132"/>
                  <a:gd name="T47" fmla="*/ 143 h 148"/>
                  <a:gd name="T48" fmla="*/ 92 w 132"/>
                  <a:gd name="T49" fmla="*/ 50 h 148"/>
                  <a:gd name="T50" fmla="*/ 91 w 132"/>
                  <a:gd name="T51" fmla="*/ 50 h 148"/>
                  <a:gd name="T52" fmla="*/ 87 w 132"/>
                  <a:gd name="T53" fmla="*/ 48 h 148"/>
                  <a:gd name="T54" fmla="*/ 77 w 132"/>
                  <a:gd name="T55" fmla="*/ 37 h 148"/>
                  <a:gd name="T56" fmla="*/ 67 w 132"/>
                  <a:gd name="T57" fmla="*/ 36 h 148"/>
                  <a:gd name="T58" fmla="*/ 65 w 132"/>
                  <a:gd name="T59" fmla="*/ 36 h 148"/>
                  <a:gd name="T60" fmla="*/ 65 w 132"/>
                  <a:gd name="T61" fmla="*/ 36 h 148"/>
                  <a:gd name="T62" fmla="*/ 65 w 132"/>
                  <a:gd name="T63" fmla="*/ 36 h 148"/>
                  <a:gd name="T64" fmla="*/ 61 w 132"/>
                  <a:gd name="T65" fmla="*/ 33 h 148"/>
                  <a:gd name="T66" fmla="*/ 64 w 132"/>
                  <a:gd name="T67" fmla="*/ 29 h 148"/>
                  <a:gd name="T68" fmla="*/ 66 w 132"/>
                  <a:gd name="T69" fmla="*/ 28 h 148"/>
                  <a:gd name="T70" fmla="*/ 79 w 132"/>
                  <a:gd name="T71" fmla="*/ 30 h 148"/>
                  <a:gd name="T72" fmla="*/ 94 w 132"/>
                  <a:gd name="T73" fmla="*/ 45 h 148"/>
                  <a:gd name="T74" fmla="*/ 92 w 132"/>
                  <a:gd name="T75" fmla="*/ 50 h 148"/>
                  <a:gd name="T76" fmla="*/ 89 w 132"/>
                  <a:gd name="T77" fmla="*/ 58 h 148"/>
                  <a:gd name="T78" fmla="*/ 92 w 132"/>
                  <a:gd name="T79" fmla="*/ 53 h 148"/>
                  <a:gd name="T80" fmla="*/ 96 w 132"/>
                  <a:gd name="T81" fmla="*/ 57 h 148"/>
                  <a:gd name="T82" fmla="*/ 93 w 132"/>
                  <a:gd name="T83" fmla="*/ 61 h 148"/>
                  <a:gd name="T84" fmla="*/ 89 w 132"/>
                  <a:gd name="T85" fmla="*/ 5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</a:cxnLst>
                <a:rect l="0" t="0" r="r" b="b"/>
                <a:pathLst>
                  <a:path w="132" h="148">
                    <a:moveTo>
                      <a:pt x="97" y="107"/>
                    </a:moveTo>
                    <a:cubicBezTo>
                      <a:pt x="73" y="126"/>
                      <a:pt x="38" y="122"/>
                      <a:pt x="19" y="98"/>
                    </a:cubicBezTo>
                    <a:cubicBezTo>
                      <a:pt x="0" y="73"/>
                      <a:pt x="4" y="38"/>
                      <a:pt x="29" y="19"/>
                    </a:cubicBezTo>
                    <a:cubicBezTo>
                      <a:pt x="53" y="0"/>
                      <a:pt x="88" y="5"/>
                      <a:pt x="107" y="29"/>
                    </a:cubicBezTo>
                    <a:cubicBezTo>
                      <a:pt x="126" y="53"/>
                      <a:pt x="122" y="88"/>
                      <a:pt x="97" y="107"/>
                    </a:cubicBezTo>
                    <a:close/>
                    <a:moveTo>
                      <a:pt x="97" y="36"/>
                    </a:moveTo>
                    <a:cubicBezTo>
                      <a:pt x="83" y="17"/>
                      <a:pt x="55" y="14"/>
                      <a:pt x="36" y="29"/>
                    </a:cubicBezTo>
                    <a:cubicBezTo>
                      <a:pt x="17" y="44"/>
                      <a:pt x="14" y="71"/>
                      <a:pt x="29" y="90"/>
                    </a:cubicBezTo>
                    <a:cubicBezTo>
                      <a:pt x="43" y="109"/>
                      <a:pt x="71" y="112"/>
                      <a:pt x="90" y="98"/>
                    </a:cubicBezTo>
                    <a:cubicBezTo>
                      <a:pt x="109" y="83"/>
                      <a:pt x="112" y="55"/>
                      <a:pt x="97" y="36"/>
                    </a:cubicBezTo>
                    <a:close/>
                    <a:moveTo>
                      <a:pt x="97" y="111"/>
                    </a:moveTo>
                    <a:cubicBezTo>
                      <a:pt x="101" y="108"/>
                      <a:pt x="101" y="108"/>
                      <a:pt x="101" y="108"/>
                    </a:cubicBezTo>
                    <a:cubicBezTo>
                      <a:pt x="104" y="106"/>
                      <a:pt x="108" y="106"/>
                      <a:pt x="110" y="109"/>
                    </a:cubicBezTo>
                    <a:cubicBezTo>
                      <a:pt x="119" y="121"/>
                      <a:pt x="119" y="121"/>
                      <a:pt x="119" y="121"/>
                    </a:cubicBezTo>
                    <a:cubicBezTo>
                      <a:pt x="106" y="132"/>
                      <a:pt x="106" y="132"/>
                      <a:pt x="106" y="132"/>
                    </a:cubicBezTo>
                    <a:cubicBezTo>
                      <a:pt x="96" y="120"/>
                      <a:pt x="96" y="120"/>
                      <a:pt x="96" y="120"/>
                    </a:cubicBezTo>
                    <a:cubicBezTo>
                      <a:pt x="94" y="117"/>
                      <a:pt x="95" y="113"/>
                      <a:pt x="97" y="111"/>
                    </a:cubicBezTo>
                    <a:close/>
                    <a:moveTo>
                      <a:pt x="128" y="143"/>
                    </a:moveTo>
                    <a:cubicBezTo>
                      <a:pt x="125" y="146"/>
                      <a:pt x="125" y="146"/>
                      <a:pt x="125" y="146"/>
                    </a:cubicBezTo>
                    <a:cubicBezTo>
                      <a:pt x="122" y="148"/>
                      <a:pt x="118" y="148"/>
                      <a:pt x="116" y="145"/>
                    </a:cubicBezTo>
                    <a:cubicBezTo>
                      <a:pt x="110" y="137"/>
                      <a:pt x="110" y="137"/>
                      <a:pt x="110" y="137"/>
                    </a:cubicBezTo>
                    <a:cubicBezTo>
                      <a:pt x="123" y="126"/>
                      <a:pt x="123" y="126"/>
                      <a:pt x="123" y="126"/>
                    </a:cubicBezTo>
                    <a:cubicBezTo>
                      <a:pt x="130" y="134"/>
                      <a:pt x="130" y="134"/>
                      <a:pt x="130" y="134"/>
                    </a:cubicBezTo>
                    <a:cubicBezTo>
                      <a:pt x="132" y="137"/>
                      <a:pt x="131" y="141"/>
                      <a:pt x="128" y="143"/>
                    </a:cubicBezTo>
                    <a:close/>
                    <a:moveTo>
                      <a:pt x="92" y="50"/>
                    </a:moveTo>
                    <a:cubicBezTo>
                      <a:pt x="91" y="50"/>
                      <a:pt x="91" y="50"/>
                      <a:pt x="91" y="50"/>
                    </a:cubicBezTo>
                    <a:cubicBezTo>
                      <a:pt x="89" y="50"/>
                      <a:pt x="88" y="49"/>
                      <a:pt x="87" y="48"/>
                    </a:cubicBezTo>
                    <a:cubicBezTo>
                      <a:pt x="84" y="41"/>
                      <a:pt x="81" y="38"/>
                      <a:pt x="77" y="37"/>
                    </a:cubicBezTo>
                    <a:cubicBezTo>
                      <a:pt x="73" y="35"/>
                      <a:pt x="69" y="35"/>
                      <a:pt x="67" y="36"/>
                    </a:cubicBezTo>
                    <a:cubicBezTo>
                      <a:pt x="66" y="36"/>
                      <a:pt x="66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3" y="36"/>
                      <a:pt x="61" y="35"/>
                      <a:pt x="61" y="33"/>
                    </a:cubicBezTo>
                    <a:cubicBezTo>
                      <a:pt x="60" y="31"/>
                      <a:pt x="62" y="29"/>
                      <a:pt x="64" y="29"/>
                    </a:cubicBezTo>
                    <a:cubicBezTo>
                      <a:pt x="64" y="29"/>
                      <a:pt x="65" y="28"/>
                      <a:pt x="66" y="28"/>
                    </a:cubicBezTo>
                    <a:cubicBezTo>
                      <a:pt x="69" y="28"/>
                      <a:pt x="74" y="28"/>
                      <a:pt x="79" y="30"/>
                    </a:cubicBezTo>
                    <a:cubicBezTo>
                      <a:pt x="85" y="32"/>
                      <a:pt x="90" y="37"/>
                      <a:pt x="94" y="45"/>
                    </a:cubicBezTo>
                    <a:cubicBezTo>
                      <a:pt x="95" y="47"/>
                      <a:pt x="94" y="49"/>
                      <a:pt x="92" y="50"/>
                    </a:cubicBezTo>
                    <a:close/>
                    <a:moveTo>
                      <a:pt x="89" y="58"/>
                    </a:moveTo>
                    <a:cubicBezTo>
                      <a:pt x="88" y="55"/>
                      <a:pt x="90" y="54"/>
                      <a:pt x="92" y="53"/>
                    </a:cubicBezTo>
                    <a:cubicBezTo>
                      <a:pt x="94" y="53"/>
                      <a:pt x="96" y="55"/>
                      <a:pt x="96" y="57"/>
                    </a:cubicBezTo>
                    <a:cubicBezTo>
                      <a:pt x="97" y="59"/>
                      <a:pt x="95" y="61"/>
                      <a:pt x="93" y="61"/>
                    </a:cubicBezTo>
                    <a:cubicBezTo>
                      <a:pt x="91" y="61"/>
                      <a:pt x="89" y="60"/>
                      <a:pt x="89" y="58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8D93B9C0-F10B-F915-8E6C-D53C014A6CBB}"/>
                </a:ext>
              </a:extLst>
            </p:cNvPr>
            <p:cNvGrpSpPr/>
            <p:nvPr/>
          </p:nvGrpSpPr>
          <p:grpSpPr>
            <a:xfrm>
              <a:off x="4185356" y="2884416"/>
              <a:ext cx="443089" cy="440267"/>
              <a:chOff x="3060700" y="3048000"/>
              <a:chExt cx="762000" cy="762000"/>
            </a:xfrm>
          </p:grpSpPr>
          <p:sp>
            <p:nvSpPr>
              <p:cNvPr id="13" name="Oval 19">
                <a:extLst>
                  <a:ext uri="{FF2B5EF4-FFF2-40B4-BE49-F238E27FC236}">
                    <a16:creationId xmlns:a16="http://schemas.microsoft.com/office/drawing/2014/main" id="{85D53E65-3004-6BF2-3EA6-5DBFA37848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0700" y="30480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Freeform 87">
                <a:extLst>
                  <a:ext uri="{FF2B5EF4-FFF2-40B4-BE49-F238E27FC236}">
                    <a16:creationId xmlns:a16="http://schemas.microsoft.com/office/drawing/2014/main" id="{1482AC61-F53E-BA2D-5C9C-E58D29B04F6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222625" y="3184525"/>
                <a:ext cx="419100" cy="469900"/>
              </a:xfrm>
              <a:custGeom>
                <a:avLst/>
                <a:gdLst>
                  <a:gd name="T0" fmla="*/ 97 w 132"/>
                  <a:gd name="T1" fmla="*/ 107 h 148"/>
                  <a:gd name="T2" fmla="*/ 19 w 132"/>
                  <a:gd name="T3" fmla="*/ 98 h 148"/>
                  <a:gd name="T4" fmla="*/ 29 w 132"/>
                  <a:gd name="T5" fmla="*/ 19 h 148"/>
                  <a:gd name="T6" fmla="*/ 107 w 132"/>
                  <a:gd name="T7" fmla="*/ 29 h 148"/>
                  <a:gd name="T8" fmla="*/ 97 w 132"/>
                  <a:gd name="T9" fmla="*/ 107 h 148"/>
                  <a:gd name="T10" fmla="*/ 97 w 132"/>
                  <a:gd name="T11" fmla="*/ 36 h 148"/>
                  <a:gd name="T12" fmla="*/ 36 w 132"/>
                  <a:gd name="T13" fmla="*/ 29 h 148"/>
                  <a:gd name="T14" fmla="*/ 29 w 132"/>
                  <a:gd name="T15" fmla="*/ 90 h 148"/>
                  <a:gd name="T16" fmla="*/ 90 w 132"/>
                  <a:gd name="T17" fmla="*/ 98 h 148"/>
                  <a:gd name="T18" fmla="*/ 97 w 132"/>
                  <a:gd name="T19" fmla="*/ 36 h 148"/>
                  <a:gd name="T20" fmla="*/ 97 w 132"/>
                  <a:gd name="T21" fmla="*/ 111 h 148"/>
                  <a:gd name="T22" fmla="*/ 101 w 132"/>
                  <a:gd name="T23" fmla="*/ 108 h 148"/>
                  <a:gd name="T24" fmla="*/ 110 w 132"/>
                  <a:gd name="T25" fmla="*/ 109 h 148"/>
                  <a:gd name="T26" fmla="*/ 119 w 132"/>
                  <a:gd name="T27" fmla="*/ 121 h 148"/>
                  <a:gd name="T28" fmla="*/ 106 w 132"/>
                  <a:gd name="T29" fmla="*/ 132 h 148"/>
                  <a:gd name="T30" fmla="*/ 96 w 132"/>
                  <a:gd name="T31" fmla="*/ 120 h 148"/>
                  <a:gd name="T32" fmla="*/ 97 w 132"/>
                  <a:gd name="T33" fmla="*/ 111 h 148"/>
                  <a:gd name="T34" fmla="*/ 128 w 132"/>
                  <a:gd name="T35" fmla="*/ 143 h 148"/>
                  <a:gd name="T36" fmla="*/ 125 w 132"/>
                  <a:gd name="T37" fmla="*/ 146 h 148"/>
                  <a:gd name="T38" fmla="*/ 116 w 132"/>
                  <a:gd name="T39" fmla="*/ 145 h 148"/>
                  <a:gd name="T40" fmla="*/ 110 w 132"/>
                  <a:gd name="T41" fmla="*/ 137 h 148"/>
                  <a:gd name="T42" fmla="*/ 123 w 132"/>
                  <a:gd name="T43" fmla="*/ 126 h 148"/>
                  <a:gd name="T44" fmla="*/ 130 w 132"/>
                  <a:gd name="T45" fmla="*/ 134 h 148"/>
                  <a:gd name="T46" fmla="*/ 128 w 132"/>
                  <a:gd name="T47" fmla="*/ 143 h 148"/>
                  <a:gd name="T48" fmla="*/ 92 w 132"/>
                  <a:gd name="T49" fmla="*/ 50 h 148"/>
                  <a:gd name="T50" fmla="*/ 91 w 132"/>
                  <a:gd name="T51" fmla="*/ 50 h 148"/>
                  <a:gd name="T52" fmla="*/ 87 w 132"/>
                  <a:gd name="T53" fmla="*/ 48 h 148"/>
                  <a:gd name="T54" fmla="*/ 77 w 132"/>
                  <a:gd name="T55" fmla="*/ 37 h 148"/>
                  <a:gd name="T56" fmla="*/ 67 w 132"/>
                  <a:gd name="T57" fmla="*/ 36 h 148"/>
                  <a:gd name="T58" fmla="*/ 65 w 132"/>
                  <a:gd name="T59" fmla="*/ 36 h 148"/>
                  <a:gd name="T60" fmla="*/ 65 w 132"/>
                  <a:gd name="T61" fmla="*/ 36 h 148"/>
                  <a:gd name="T62" fmla="*/ 65 w 132"/>
                  <a:gd name="T63" fmla="*/ 36 h 148"/>
                  <a:gd name="T64" fmla="*/ 61 w 132"/>
                  <a:gd name="T65" fmla="*/ 33 h 148"/>
                  <a:gd name="T66" fmla="*/ 64 w 132"/>
                  <a:gd name="T67" fmla="*/ 29 h 148"/>
                  <a:gd name="T68" fmla="*/ 66 w 132"/>
                  <a:gd name="T69" fmla="*/ 28 h 148"/>
                  <a:gd name="T70" fmla="*/ 79 w 132"/>
                  <a:gd name="T71" fmla="*/ 30 h 148"/>
                  <a:gd name="T72" fmla="*/ 94 w 132"/>
                  <a:gd name="T73" fmla="*/ 45 h 148"/>
                  <a:gd name="T74" fmla="*/ 92 w 132"/>
                  <a:gd name="T75" fmla="*/ 50 h 148"/>
                  <a:gd name="T76" fmla="*/ 89 w 132"/>
                  <a:gd name="T77" fmla="*/ 58 h 148"/>
                  <a:gd name="T78" fmla="*/ 92 w 132"/>
                  <a:gd name="T79" fmla="*/ 53 h 148"/>
                  <a:gd name="T80" fmla="*/ 96 w 132"/>
                  <a:gd name="T81" fmla="*/ 57 h 148"/>
                  <a:gd name="T82" fmla="*/ 93 w 132"/>
                  <a:gd name="T83" fmla="*/ 61 h 148"/>
                  <a:gd name="T84" fmla="*/ 89 w 132"/>
                  <a:gd name="T85" fmla="*/ 5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</a:cxnLst>
                <a:rect l="0" t="0" r="r" b="b"/>
                <a:pathLst>
                  <a:path w="132" h="148">
                    <a:moveTo>
                      <a:pt x="97" y="107"/>
                    </a:moveTo>
                    <a:cubicBezTo>
                      <a:pt x="73" y="126"/>
                      <a:pt x="38" y="122"/>
                      <a:pt x="19" y="98"/>
                    </a:cubicBezTo>
                    <a:cubicBezTo>
                      <a:pt x="0" y="73"/>
                      <a:pt x="4" y="38"/>
                      <a:pt x="29" y="19"/>
                    </a:cubicBezTo>
                    <a:cubicBezTo>
                      <a:pt x="53" y="0"/>
                      <a:pt x="88" y="5"/>
                      <a:pt x="107" y="29"/>
                    </a:cubicBezTo>
                    <a:cubicBezTo>
                      <a:pt x="126" y="53"/>
                      <a:pt x="122" y="88"/>
                      <a:pt x="97" y="107"/>
                    </a:cubicBezTo>
                    <a:close/>
                    <a:moveTo>
                      <a:pt x="97" y="36"/>
                    </a:moveTo>
                    <a:cubicBezTo>
                      <a:pt x="83" y="17"/>
                      <a:pt x="55" y="14"/>
                      <a:pt x="36" y="29"/>
                    </a:cubicBezTo>
                    <a:cubicBezTo>
                      <a:pt x="17" y="44"/>
                      <a:pt x="14" y="71"/>
                      <a:pt x="29" y="90"/>
                    </a:cubicBezTo>
                    <a:cubicBezTo>
                      <a:pt x="43" y="109"/>
                      <a:pt x="71" y="112"/>
                      <a:pt x="90" y="98"/>
                    </a:cubicBezTo>
                    <a:cubicBezTo>
                      <a:pt x="109" y="83"/>
                      <a:pt x="112" y="55"/>
                      <a:pt x="97" y="36"/>
                    </a:cubicBezTo>
                    <a:close/>
                    <a:moveTo>
                      <a:pt x="97" y="111"/>
                    </a:moveTo>
                    <a:cubicBezTo>
                      <a:pt x="101" y="108"/>
                      <a:pt x="101" y="108"/>
                      <a:pt x="101" y="108"/>
                    </a:cubicBezTo>
                    <a:cubicBezTo>
                      <a:pt x="104" y="106"/>
                      <a:pt x="108" y="106"/>
                      <a:pt x="110" y="109"/>
                    </a:cubicBezTo>
                    <a:cubicBezTo>
                      <a:pt x="119" y="121"/>
                      <a:pt x="119" y="121"/>
                      <a:pt x="119" y="121"/>
                    </a:cubicBezTo>
                    <a:cubicBezTo>
                      <a:pt x="106" y="132"/>
                      <a:pt x="106" y="132"/>
                      <a:pt x="106" y="132"/>
                    </a:cubicBezTo>
                    <a:cubicBezTo>
                      <a:pt x="96" y="120"/>
                      <a:pt x="96" y="120"/>
                      <a:pt x="96" y="120"/>
                    </a:cubicBezTo>
                    <a:cubicBezTo>
                      <a:pt x="94" y="117"/>
                      <a:pt x="95" y="113"/>
                      <a:pt x="97" y="111"/>
                    </a:cubicBezTo>
                    <a:close/>
                    <a:moveTo>
                      <a:pt x="128" y="143"/>
                    </a:moveTo>
                    <a:cubicBezTo>
                      <a:pt x="125" y="146"/>
                      <a:pt x="125" y="146"/>
                      <a:pt x="125" y="146"/>
                    </a:cubicBezTo>
                    <a:cubicBezTo>
                      <a:pt x="122" y="148"/>
                      <a:pt x="118" y="148"/>
                      <a:pt x="116" y="145"/>
                    </a:cubicBezTo>
                    <a:cubicBezTo>
                      <a:pt x="110" y="137"/>
                      <a:pt x="110" y="137"/>
                      <a:pt x="110" y="137"/>
                    </a:cubicBezTo>
                    <a:cubicBezTo>
                      <a:pt x="123" y="126"/>
                      <a:pt x="123" y="126"/>
                      <a:pt x="123" y="126"/>
                    </a:cubicBezTo>
                    <a:cubicBezTo>
                      <a:pt x="130" y="134"/>
                      <a:pt x="130" y="134"/>
                      <a:pt x="130" y="134"/>
                    </a:cubicBezTo>
                    <a:cubicBezTo>
                      <a:pt x="132" y="137"/>
                      <a:pt x="131" y="141"/>
                      <a:pt x="128" y="143"/>
                    </a:cubicBezTo>
                    <a:close/>
                    <a:moveTo>
                      <a:pt x="92" y="50"/>
                    </a:moveTo>
                    <a:cubicBezTo>
                      <a:pt x="91" y="50"/>
                      <a:pt x="91" y="50"/>
                      <a:pt x="91" y="50"/>
                    </a:cubicBezTo>
                    <a:cubicBezTo>
                      <a:pt x="89" y="50"/>
                      <a:pt x="88" y="49"/>
                      <a:pt x="87" y="48"/>
                    </a:cubicBezTo>
                    <a:cubicBezTo>
                      <a:pt x="84" y="41"/>
                      <a:pt x="81" y="38"/>
                      <a:pt x="77" y="37"/>
                    </a:cubicBezTo>
                    <a:cubicBezTo>
                      <a:pt x="73" y="35"/>
                      <a:pt x="69" y="35"/>
                      <a:pt x="67" y="36"/>
                    </a:cubicBezTo>
                    <a:cubicBezTo>
                      <a:pt x="66" y="36"/>
                      <a:pt x="66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3" y="36"/>
                      <a:pt x="61" y="35"/>
                      <a:pt x="61" y="33"/>
                    </a:cubicBezTo>
                    <a:cubicBezTo>
                      <a:pt x="60" y="31"/>
                      <a:pt x="62" y="29"/>
                      <a:pt x="64" y="29"/>
                    </a:cubicBezTo>
                    <a:cubicBezTo>
                      <a:pt x="64" y="29"/>
                      <a:pt x="65" y="28"/>
                      <a:pt x="66" y="28"/>
                    </a:cubicBezTo>
                    <a:cubicBezTo>
                      <a:pt x="69" y="28"/>
                      <a:pt x="74" y="28"/>
                      <a:pt x="79" y="30"/>
                    </a:cubicBezTo>
                    <a:cubicBezTo>
                      <a:pt x="85" y="32"/>
                      <a:pt x="90" y="37"/>
                      <a:pt x="94" y="45"/>
                    </a:cubicBezTo>
                    <a:cubicBezTo>
                      <a:pt x="95" y="47"/>
                      <a:pt x="94" y="49"/>
                      <a:pt x="92" y="50"/>
                    </a:cubicBezTo>
                    <a:close/>
                    <a:moveTo>
                      <a:pt x="89" y="58"/>
                    </a:moveTo>
                    <a:cubicBezTo>
                      <a:pt x="88" y="55"/>
                      <a:pt x="90" y="54"/>
                      <a:pt x="92" y="53"/>
                    </a:cubicBezTo>
                    <a:cubicBezTo>
                      <a:pt x="94" y="53"/>
                      <a:pt x="96" y="55"/>
                      <a:pt x="96" y="57"/>
                    </a:cubicBezTo>
                    <a:cubicBezTo>
                      <a:pt x="97" y="59"/>
                      <a:pt x="95" y="61"/>
                      <a:pt x="93" y="61"/>
                    </a:cubicBezTo>
                    <a:cubicBezTo>
                      <a:pt x="91" y="61"/>
                      <a:pt x="89" y="60"/>
                      <a:pt x="89" y="58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4B1BD898-F827-900A-9FBD-7025F6B49786}"/>
                </a:ext>
              </a:extLst>
            </p:cNvPr>
            <p:cNvGrpSpPr/>
            <p:nvPr/>
          </p:nvGrpSpPr>
          <p:grpSpPr>
            <a:xfrm>
              <a:off x="4179816" y="3679896"/>
              <a:ext cx="443089" cy="440267"/>
              <a:chOff x="3060700" y="3048000"/>
              <a:chExt cx="762000" cy="762000"/>
            </a:xfrm>
          </p:grpSpPr>
          <p:sp>
            <p:nvSpPr>
              <p:cNvPr id="16" name="Oval 19">
                <a:extLst>
                  <a:ext uri="{FF2B5EF4-FFF2-40B4-BE49-F238E27FC236}">
                    <a16:creationId xmlns:a16="http://schemas.microsoft.com/office/drawing/2014/main" id="{FD92B339-7479-5FA2-0AE3-68D9DA04CF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0700" y="30480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Freeform 87">
                <a:extLst>
                  <a:ext uri="{FF2B5EF4-FFF2-40B4-BE49-F238E27FC236}">
                    <a16:creationId xmlns:a16="http://schemas.microsoft.com/office/drawing/2014/main" id="{107C3E4E-8869-91EA-CB07-D96767A27F2E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222625" y="3184525"/>
                <a:ext cx="419100" cy="469900"/>
              </a:xfrm>
              <a:custGeom>
                <a:avLst/>
                <a:gdLst>
                  <a:gd name="T0" fmla="*/ 97 w 132"/>
                  <a:gd name="T1" fmla="*/ 107 h 148"/>
                  <a:gd name="T2" fmla="*/ 19 w 132"/>
                  <a:gd name="T3" fmla="*/ 98 h 148"/>
                  <a:gd name="T4" fmla="*/ 29 w 132"/>
                  <a:gd name="T5" fmla="*/ 19 h 148"/>
                  <a:gd name="T6" fmla="*/ 107 w 132"/>
                  <a:gd name="T7" fmla="*/ 29 h 148"/>
                  <a:gd name="T8" fmla="*/ 97 w 132"/>
                  <a:gd name="T9" fmla="*/ 107 h 148"/>
                  <a:gd name="T10" fmla="*/ 97 w 132"/>
                  <a:gd name="T11" fmla="*/ 36 h 148"/>
                  <a:gd name="T12" fmla="*/ 36 w 132"/>
                  <a:gd name="T13" fmla="*/ 29 h 148"/>
                  <a:gd name="T14" fmla="*/ 29 w 132"/>
                  <a:gd name="T15" fmla="*/ 90 h 148"/>
                  <a:gd name="T16" fmla="*/ 90 w 132"/>
                  <a:gd name="T17" fmla="*/ 98 h 148"/>
                  <a:gd name="T18" fmla="*/ 97 w 132"/>
                  <a:gd name="T19" fmla="*/ 36 h 148"/>
                  <a:gd name="T20" fmla="*/ 97 w 132"/>
                  <a:gd name="T21" fmla="*/ 111 h 148"/>
                  <a:gd name="T22" fmla="*/ 101 w 132"/>
                  <a:gd name="T23" fmla="*/ 108 h 148"/>
                  <a:gd name="T24" fmla="*/ 110 w 132"/>
                  <a:gd name="T25" fmla="*/ 109 h 148"/>
                  <a:gd name="T26" fmla="*/ 119 w 132"/>
                  <a:gd name="T27" fmla="*/ 121 h 148"/>
                  <a:gd name="T28" fmla="*/ 106 w 132"/>
                  <a:gd name="T29" fmla="*/ 132 h 148"/>
                  <a:gd name="T30" fmla="*/ 96 w 132"/>
                  <a:gd name="T31" fmla="*/ 120 h 148"/>
                  <a:gd name="T32" fmla="*/ 97 w 132"/>
                  <a:gd name="T33" fmla="*/ 111 h 148"/>
                  <a:gd name="T34" fmla="*/ 128 w 132"/>
                  <a:gd name="T35" fmla="*/ 143 h 148"/>
                  <a:gd name="T36" fmla="*/ 125 w 132"/>
                  <a:gd name="T37" fmla="*/ 146 h 148"/>
                  <a:gd name="T38" fmla="*/ 116 w 132"/>
                  <a:gd name="T39" fmla="*/ 145 h 148"/>
                  <a:gd name="T40" fmla="*/ 110 w 132"/>
                  <a:gd name="T41" fmla="*/ 137 h 148"/>
                  <a:gd name="T42" fmla="*/ 123 w 132"/>
                  <a:gd name="T43" fmla="*/ 126 h 148"/>
                  <a:gd name="T44" fmla="*/ 130 w 132"/>
                  <a:gd name="T45" fmla="*/ 134 h 148"/>
                  <a:gd name="T46" fmla="*/ 128 w 132"/>
                  <a:gd name="T47" fmla="*/ 143 h 148"/>
                  <a:gd name="T48" fmla="*/ 92 w 132"/>
                  <a:gd name="T49" fmla="*/ 50 h 148"/>
                  <a:gd name="T50" fmla="*/ 91 w 132"/>
                  <a:gd name="T51" fmla="*/ 50 h 148"/>
                  <a:gd name="T52" fmla="*/ 87 w 132"/>
                  <a:gd name="T53" fmla="*/ 48 h 148"/>
                  <a:gd name="T54" fmla="*/ 77 w 132"/>
                  <a:gd name="T55" fmla="*/ 37 h 148"/>
                  <a:gd name="T56" fmla="*/ 67 w 132"/>
                  <a:gd name="T57" fmla="*/ 36 h 148"/>
                  <a:gd name="T58" fmla="*/ 65 w 132"/>
                  <a:gd name="T59" fmla="*/ 36 h 148"/>
                  <a:gd name="T60" fmla="*/ 65 w 132"/>
                  <a:gd name="T61" fmla="*/ 36 h 148"/>
                  <a:gd name="T62" fmla="*/ 65 w 132"/>
                  <a:gd name="T63" fmla="*/ 36 h 148"/>
                  <a:gd name="T64" fmla="*/ 61 w 132"/>
                  <a:gd name="T65" fmla="*/ 33 h 148"/>
                  <a:gd name="T66" fmla="*/ 64 w 132"/>
                  <a:gd name="T67" fmla="*/ 29 h 148"/>
                  <a:gd name="T68" fmla="*/ 66 w 132"/>
                  <a:gd name="T69" fmla="*/ 28 h 148"/>
                  <a:gd name="T70" fmla="*/ 79 w 132"/>
                  <a:gd name="T71" fmla="*/ 30 h 148"/>
                  <a:gd name="T72" fmla="*/ 94 w 132"/>
                  <a:gd name="T73" fmla="*/ 45 h 148"/>
                  <a:gd name="T74" fmla="*/ 92 w 132"/>
                  <a:gd name="T75" fmla="*/ 50 h 148"/>
                  <a:gd name="T76" fmla="*/ 89 w 132"/>
                  <a:gd name="T77" fmla="*/ 58 h 148"/>
                  <a:gd name="T78" fmla="*/ 92 w 132"/>
                  <a:gd name="T79" fmla="*/ 53 h 148"/>
                  <a:gd name="T80" fmla="*/ 96 w 132"/>
                  <a:gd name="T81" fmla="*/ 57 h 148"/>
                  <a:gd name="T82" fmla="*/ 93 w 132"/>
                  <a:gd name="T83" fmla="*/ 61 h 148"/>
                  <a:gd name="T84" fmla="*/ 89 w 132"/>
                  <a:gd name="T85" fmla="*/ 5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</a:cxnLst>
                <a:rect l="0" t="0" r="r" b="b"/>
                <a:pathLst>
                  <a:path w="132" h="148">
                    <a:moveTo>
                      <a:pt x="97" y="107"/>
                    </a:moveTo>
                    <a:cubicBezTo>
                      <a:pt x="73" y="126"/>
                      <a:pt x="38" y="122"/>
                      <a:pt x="19" y="98"/>
                    </a:cubicBezTo>
                    <a:cubicBezTo>
                      <a:pt x="0" y="73"/>
                      <a:pt x="4" y="38"/>
                      <a:pt x="29" y="19"/>
                    </a:cubicBezTo>
                    <a:cubicBezTo>
                      <a:pt x="53" y="0"/>
                      <a:pt x="88" y="5"/>
                      <a:pt x="107" y="29"/>
                    </a:cubicBezTo>
                    <a:cubicBezTo>
                      <a:pt x="126" y="53"/>
                      <a:pt x="122" y="88"/>
                      <a:pt x="97" y="107"/>
                    </a:cubicBezTo>
                    <a:close/>
                    <a:moveTo>
                      <a:pt x="97" y="36"/>
                    </a:moveTo>
                    <a:cubicBezTo>
                      <a:pt x="83" y="17"/>
                      <a:pt x="55" y="14"/>
                      <a:pt x="36" y="29"/>
                    </a:cubicBezTo>
                    <a:cubicBezTo>
                      <a:pt x="17" y="44"/>
                      <a:pt x="14" y="71"/>
                      <a:pt x="29" y="90"/>
                    </a:cubicBezTo>
                    <a:cubicBezTo>
                      <a:pt x="43" y="109"/>
                      <a:pt x="71" y="112"/>
                      <a:pt x="90" y="98"/>
                    </a:cubicBezTo>
                    <a:cubicBezTo>
                      <a:pt x="109" y="83"/>
                      <a:pt x="112" y="55"/>
                      <a:pt x="97" y="36"/>
                    </a:cubicBezTo>
                    <a:close/>
                    <a:moveTo>
                      <a:pt x="97" y="111"/>
                    </a:moveTo>
                    <a:cubicBezTo>
                      <a:pt x="101" y="108"/>
                      <a:pt x="101" y="108"/>
                      <a:pt x="101" y="108"/>
                    </a:cubicBezTo>
                    <a:cubicBezTo>
                      <a:pt x="104" y="106"/>
                      <a:pt x="108" y="106"/>
                      <a:pt x="110" y="109"/>
                    </a:cubicBezTo>
                    <a:cubicBezTo>
                      <a:pt x="119" y="121"/>
                      <a:pt x="119" y="121"/>
                      <a:pt x="119" y="121"/>
                    </a:cubicBezTo>
                    <a:cubicBezTo>
                      <a:pt x="106" y="132"/>
                      <a:pt x="106" y="132"/>
                      <a:pt x="106" y="132"/>
                    </a:cubicBezTo>
                    <a:cubicBezTo>
                      <a:pt x="96" y="120"/>
                      <a:pt x="96" y="120"/>
                      <a:pt x="96" y="120"/>
                    </a:cubicBezTo>
                    <a:cubicBezTo>
                      <a:pt x="94" y="117"/>
                      <a:pt x="95" y="113"/>
                      <a:pt x="97" y="111"/>
                    </a:cubicBezTo>
                    <a:close/>
                    <a:moveTo>
                      <a:pt x="128" y="143"/>
                    </a:moveTo>
                    <a:cubicBezTo>
                      <a:pt x="125" y="146"/>
                      <a:pt x="125" y="146"/>
                      <a:pt x="125" y="146"/>
                    </a:cubicBezTo>
                    <a:cubicBezTo>
                      <a:pt x="122" y="148"/>
                      <a:pt x="118" y="148"/>
                      <a:pt x="116" y="145"/>
                    </a:cubicBezTo>
                    <a:cubicBezTo>
                      <a:pt x="110" y="137"/>
                      <a:pt x="110" y="137"/>
                      <a:pt x="110" y="137"/>
                    </a:cubicBezTo>
                    <a:cubicBezTo>
                      <a:pt x="123" y="126"/>
                      <a:pt x="123" y="126"/>
                      <a:pt x="123" y="126"/>
                    </a:cubicBezTo>
                    <a:cubicBezTo>
                      <a:pt x="130" y="134"/>
                      <a:pt x="130" y="134"/>
                      <a:pt x="130" y="134"/>
                    </a:cubicBezTo>
                    <a:cubicBezTo>
                      <a:pt x="132" y="137"/>
                      <a:pt x="131" y="141"/>
                      <a:pt x="128" y="143"/>
                    </a:cubicBezTo>
                    <a:close/>
                    <a:moveTo>
                      <a:pt x="92" y="50"/>
                    </a:moveTo>
                    <a:cubicBezTo>
                      <a:pt x="91" y="50"/>
                      <a:pt x="91" y="50"/>
                      <a:pt x="91" y="50"/>
                    </a:cubicBezTo>
                    <a:cubicBezTo>
                      <a:pt x="89" y="50"/>
                      <a:pt x="88" y="49"/>
                      <a:pt x="87" y="48"/>
                    </a:cubicBezTo>
                    <a:cubicBezTo>
                      <a:pt x="84" y="41"/>
                      <a:pt x="81" y="38"/>
                      <a:pt x="77" y="37"/>
                    </a:cubicBezTo>
                    <a:cubicBezTo>
                      <a:pt x="73" y="35"/>
                      <a:pt x="69" y="35"/>
                      <a:pt x="67" y="36"/>
                    </a:cubicBezTo>
                    <a:cubicBezTo>
                      <a:pt x="66" y="36"/>
                      <a:pt x="66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3" y="36"/>
                      <a:pt x="61" y="35"/>
                      <a:pt x="61" y="33"/>
                    </a:cubicBezTo>
                    <a:cubicBezTo>
                      <a:pt x="60" y="31"/>
                      <a:pt x="62" y="29"/>
                      <a:pt x="64" y="29"/>
                    </a:cubicBezTo>
                    <a:cubicBezTo>
                      <a:pt x="64" y="29"/>
                      <a:pt x="65" y="28"/>
                      <a:pt x="66" y="28"/>
                    </a:cubicBezTo>
                    <a:cubicBezTo>
                      <a:pt x="69" y="28"/>
                      <a:pt x="74" y="28"/>
                      <a:pt x="79" y="30"/>
                    </a:cubicBezTo>
                    <a:cubicBezTo>
                      <a:pt x="85" y="32"/>
                      <a:pt x="90" y="37"/>
                      <a:pt x="94" y="45"/>
                    </a:cubicBezTo>
                    <a:cubicBezTo>
                      <a:pt x="95" y="47"/>
                      <a:pt x="94" y="49"/>
                      <a:pt x="92" y="50"/>
                    </a:cubicBezTo>
                    <a:close/>
                    <a:moveTo>
                      <a:pt x="89" y="58"/>
                    </a:moveTo>
                    <a:cubicBezTo>
                      <a:pt x="88" y="55"/>
                      <a:pt x="90" y="54"/>
                      <a:pt x="92" y="53"/>
                    </a:cubicBezTo>
                    <a:cubicBezTo>
                      <a:pt x="94" y="53"/>
                      <a:pt x="96" y="55"/>
                      <a:pt x="96" y="57"/>
                    </a:cubicBezTo>
                    <a:cubicBezTo>
                      <a:pt x="97" y="59"/>
                      <a:pt x="95" y="61"/>
                      <a:pt x="93" y="61"/>
                    </a:cubicBezTo>
                    <a:cubicBezTo>
                      <a:pt x="91" y="61"/>
                      <a:pt x="89" y="60"/>
                      <a:pt x="89" y="58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08C6E544-C1E0-79BB-C925-646198C5BF82}"/>
                </a:ext>
              </a:extLst>
            </p:cNvPr>
            <p:cNvGrpSpPr/>
            <p:nvPr/>
          </p:nvGrpSpPr>
          <p:grpSpPr>
            <a:xfrm>
              <a:off x="4174276" y="4463275"/>
              <a:ext cx="443089" cy="440267"/>
              <a:chOff x="3060700" y="3048000"/>
              <a:chExt cx="762000" cy="762000"/>
            </a:xfrm>
          </p:grpSpPr>
          <p:sp>
            <p:nvSpPr>
              <p:cNvPr id="19" name="Oval 19">
                <a:extLst>
                  <a:ext uri="{FF2B5EF4-FFF2-40B4-BE49-F238E27FC236}">
                    <a16:creationId xmlns:a16="http://schemas.microsoft.com/office/drawing/2014/main" id="{B56F9960-8156-AF0C-BC53-522EEEA097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0700" y="30480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Freeform 87">
                <a:extLst>
                  <a:ext uri="{FF2B5EF4-FFF2-40B4-BE49-F238E27FC236}">
                    <a16:creationId xmlns:a16="http://schemas.microsoft.com/office/drawing/2014/main" id="{016EDEC6-5F1C-FADA-BE8C-F73ECA28C9F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222625" y="3184525"/>
                <a:ext cx="419100" cy="469900"/>
              </a:xfrm>
              <a:custGeom>
                <a:avLst/>
                <a:gdLst>
                  <a:gd name="T0" fmla="*/ 97 w 132"/>
                  <a:gd name="T1" fmla="*/ 107 h 148"/>
                  <a:gd name="T2" fmla="*/ 19 w 132"/>
                  <a:gd name="T3" fmla="*/ 98 h 148"/>
                  <a:gd name="T4" fmla="*/ 29 w 132"/>
                  <a:gd name="T5" fmla="*/ 19 h 148"/>
                  <a:gd name="T6" fmla="*/ 107 w 132"/>
                  <a:gd name="T7" fmla="*/ 29 h 148"/>
                  <a:gd name="T8" fmla="*/ 97 w 132"/>
                  <a:gd name="T9" fmla="*/ 107 h 148"/>
                  <a:gd name="T10" fmla="*/ 97 w 132"/>
                  <a:gd name="T11" fmla="*/ 36 h 148"/>
                  <a:gd name="T12" fmla="*/ 36 w 132"/>
                  <a:gd name="T13" fmla="*/ 29 h 148"/>
                  <a:gd name="T14" fmla="*/ 29 w 132"/>
                  <a:gd name="T15" fmla="*/ 90 h 148"/>
                  <a:gd name="T16" fmla="*/ 90 w 132"/>
                  <a:gd name="T17" fmla="*/ 98 h 148"/>
                  <a:gd name="T18" fmla="*/ 97 w 132"/>
                  <a:gd name="T19" fmla="*/ 36 h 148"/>
                  <a:gd name="T20" fmla="*/ 97 w 132"/>
                  <a:gd name="T21" fmla="*/ 111 h 148"/>
                  <a:gd name="T22" fmla="*/ 101 w 132"/>
                  <a:gd name="T23" fmla="*/ 108 h 148"/>
                  <a:gd name="T24" fmla="*/ 110 w 132"/>
                  <a:gd name="T25" fmla="*/ 109 h 148"/>
                  <a:gd name="T26" fmla="*/ 119 w 132"/>
                  <a:gd name="T27" fmla="*/ 121 h 148"/>
                  <a:gd name="T28" fmla="*/ 106 w 132"/>
                  <a:gd name="T29" fmla="*/ 132 h 148"/>
                  <a:gd name="T30" fmla="*/ 96 w 132"/>
                  <a:gd name="T31" fmla="*/ 120 h 148"/>
                  <a:gd name="T32" fmla="*/ 97 w 132"/>
                  <a:gd name="T33" fmla="*/ 111 h 148"/>
                  <a:gd name="T34" fmla="*/ 128 w 132"/>
                  <a:gd name="T35" fmla="*/ 143 h 148"/>
                  <a:gd name="T36" fmla="*/ 125 w 132"/>
                  <a:gd name="T37" fmla="*/ 146 h 148"/>
                  <a:gd name="T38" fmla="*/ 116 w 132"/>
                  <a:gd name="T39" fmla="*/ 145 h 148"/>
                  <a:gd name="T40" fmla="*/ 110 w 132"/>
                  <a:gd name="T41" fmla="*/ 137 h 148"/>
                  <a:gd name="T42" fmla="*/ 123 w 132"/>
                  <a:gd name="T43" fmla="*/ 126 h 148"/>
                  <a:gd name="T44" fmla="*/ 130 w 132"/>
                  <a:gd name="T45" fmla="*/ 134 h 148"/>
                  <a:gd name="T46" fmla="*/ 128 w 132"/>
                  <a:gd name="T47" fmla="*/ 143 h 148"/>
                  <a:gd name="T48" fmla="*/ 92 w 132"/>
                  <a:gd name="T49" fmla="*/ 50 h 148"/>
                  <a:gd name="T50" fmla="*/ 91 w 132"/>
                  <a:gd name="T51" fmla="*/ 50 h 148"/>
                  <a:gd name="T52" fmla="*/ 87 w 132"/>
                  <a:gd name="T53" fmla="*/ 48 h 148"/>
                  <a:gd name="T54" fmla="*/ 77 w 132"/>
                  <a:gd name="T55" fmla="*/ 37 h 148"/>
                  <a:gd name="T56" fmla="*/ 67 w 132"/>
                  <a:gd name="T57" fmla="*/ 36 h 148"/>
                  <a:gd name="T58" fmla="*/ 65 w 132"/>
                  <a:gd name="T59" fmla="*/ 36 h 148"/>
                  <a:gd name="T60" fmla="*/ 65 w 132"/>
                  <a:gd name="T61" fmla="*/ 36 h 148"/>
                  <a:gd name="T62" fmla="*/ 65 w 132"/>
                  <a:gd name="T63" fmla="*/ 36 h 148"/>
                  <a:gd name="T64" fmla="*/ 61 w 132"/>
                  <a:gd name="T65" fmla="*/ 33 h 148"/>
                  <a:gd name="T66" fmla="*/ 64 w 132"/>
                  <a:gd name="T67" fmla="*/ 29 h 148"/>
                  <a:gd name="T68" fmla="*/ 66 w 132"/>
                  <a:gd name="T69" fmla="*/ 28 h 148"/>
                  <a:gd name="T70" fmla="*/ 79 w 132"/>
                  <a:gd name="T71" fmla="*/ 30 h 148"/>
                  <a:gd name="T72" fmla="*/ 94 w 132"/>
                  <a:gd name="T73" fmla="*/ 45 h 148"/>
                  <a:gd name="T74" fmla="*/ 92 w 132"/>
                  <a:gd name="T75" fmla="*/ 50 h 148"/>
                  <a:gd name="T76" fmla="*/ 89 w 132"/>
                  <a:gd name="T77" fmla="*/ 58 h 148"/>
                  <a:gd name="T78" fmla="*/ 92 w 132"/>
                  <a:gd name="T79" fmla="*/ 53 h 148"/>
                  <a:gd name="T80" fmla="*/ 96 w 132"/>
                  <a:gd name="T81" fmla="*/ 57 h 148"/>
                  <a:gd name="T82" fmla="*/ 93 w 132"/>
                  <a:gd name="T83" fmla="*/ 61 h 148"/>
                  <a:gd name="T84" fmla="*/ 89 w 132"/>
                  <a:gd name="T85" fmla="*/ 58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</a:cxnLst>
                <a:rect l="0" t="0" r="r" b="b"/>
                <a:pathLst>
                  <a:path w="132" h="148">
                    <a:moveTo>
                      <a:pt x="97" y="107"/>
                    </a:moveTo>
                    <a:cubicBezTo>
                      <a:pt x="73" y="126"/>
                      <a:pt x="38" y="122"/>
                      <a:pt x="19" y="98"/>
                    </a:cubicBezTo>
                    <a:cubicBezTo>
                      <a:pt x="0" y="73"/>
                      <a:pt x="4" y="38"/>
                      <a:pt x="29" y="19"/>
                    </a:cubicBezTo>
                    <a:cubicBezTo>
                      <a:pt x="53" y="0"/>
                      <a:pt x="88" y="5"/>
                      <a:pt x="107" y="29"/>
                    </a:cubicBezTo>
                    <a:cubicBezTo>
                      <a:pt x="126" y="53"/>
                      <a:pt x="122" y="88"/>
                      <a:pt x="97" y="107"/>
                    </a:cubicBezTo>
                    <a:close/>
                    <a:moveTo>
                      <a:pt x="97" y="36"/>
                    </a:moveTo>
                    <a:cubicBezTo>
                      <a:pt x="83" y="17"/>
                      <a:pt x="55" y="14"/>
                      <a:pt x="36" y="29"/>
                    </a:cubicBezTo>
                    <a:cubicBezTo>
                      <a:pt x="17" y="44"/>
                      <a:pt x="14" y="71"/>
                      <a:pt x="29" y="90"/>
                    </a:cubicBezTo>
                    <a:cubicBezTo>
                      <a:pt x="43" y="109"/>
                      <a:pt x="71" y="112"/>
                      <a:pt x="90" y="98"/>
                    </a:cubicBezTo>
                    <a:cubicBezTo>
                      <a:pt x="109" y="83"/>
                      <a:pt x="112" y="55"/>
                      <a:pt x="97" y="36"/>
                    </a:cubicBezTo>
                    <a:close/>
                    <a:moveTo>
                      <a:pt x="97" y="111"/>
                    </a:moveTo>
                    <a:cubicBezTo>
                      <a:pt x="101" y="108"/>
                      <a:pt x="101" y="108"/>
                      <a:pt x="101" y="108"/>
                    </a:cubicBezTo>
                    <a:cubicBezTo>
                      <a:pt x="104" y="106"/>
                      <a:pt x="108" y="106"/>
                      <a:pt x="110" y="109"/>
                    </a:cubicBezTo>
                    <a:cubicBezTo>
                      <a:pt x="119" y="121"/>
                      <a:pt x="119" y="121"/>
                      <a:pt x="119" y="121"/>
                    </a:cubicBezTo>
                    <a:cubicBezTo>
                      <a:pt x="106" y="132"/>
                      <a:pt x="106" y="132"/>
                      <a:pt x="106" y="132"/>
                    </a:cubicBezTo>
                    <a:cubicBezTo>
                      <a:pt x="96" y="120"/>
                      <a:pt x="96" y="120"/>
                      <a:pt x="96" y="120"/>
                    </a:cubicBezTo>
                    <a:cubicBezTo>
                      <a:pt x="94" y="117"/>
                      <a:pt x="95" y="113"/>
                      <a:pt x="97" y="111"/>
                    </a:cubicBezTo>
                    <a:close/>
                    <a:moveTo>
                      <a:pt x="128" y="143"/>
                    </a:moveTo>
                    <a:cubicBezTo>
                      <a:pt x="125" y="146"/>
                      <a:pt x="125" y="146"/>
                      <a:pt x="125" y="146"/>
                    </a:cubicBezTo>
                    <a:cubicBezTo>
                      <a:pt x="122" y="148"/>
                      <a:pt x="118" y="148"/>
                      <a:pt x="116" y="145"/>
                    </a:cubicBezTo>
                    <a:cubicBezTo>
                      <a:pt x="110" y="137"/>
                      <a:pt x="110" y="137"/>
                      <a:pt x="110" y="137"/>
                    </a:cubicBezTo>
                    <a:cubicBezTo>
                      <a:pt x="123" y="126"/>
                      <a:pt x="123" y="126"/>
                      <a:pt x="123" y="126"/>
                    </a:cubicBezTo>
                    <a:cubicBezTo>
                      <a:pt x="130" y="134"/>
                      <a:pt x="130" y="134"/>
                      <a:pt x="130" y="134"/>
                    </a:cubicBezTo>
                    <a:cubicBezTo>
                      <a:pt x="132" y="137"/>
                      <a:pt x="131" y="141"/>
                      <a:pt x="128" y="143"/>
                    </a:cubicBezTo>
                    <a:close/>
                    <a:moveTo>
                      <a:pt x="92" y="50"/>
                    </a:moveTo>
                    <a:cubicBezTo>
                      <a:pt x="91" y="50"/>
                      <a:pt x="91" y="50"/>
                      <a:pt x="91" y="50"/>
                    </a:cubicBezTo>
                    <a:cubicBezTo>
                      <a:pt x="89" y="50"/>
                      <a:pt x="88" y="49"/>
                      <a:pt x="87" y="48"/>
                    </a:cubicBezTo>
                    <a:cubicBezTo>
                      <a:pt x="84" y="41"/>
                      <a:pt x="81" y="38"/>
                      <a:pt x="77" y="37"/>
                    </a:cubicBezTo>
                    <a:cubicBezTo>
                      <a:pt x="73" y="35"/>
                      <a:pt x="69" y="35"/>
                      <a:pt x="67" y="36"/>
                    </a:cubicBezTo>
                    <a:cubicBezTo>
                      <a:pt x="66" y="36"/>
                      <a:pt x="66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5" y="36"/>
                      <a:pt x="65" y="36"/>
                      <a:pt x="65" y="36"/>
                    </a:cubicBezTo>
                    <a:cubicBezTo>
                      <a:pt x="63" y="36"/>
                      <a:pt x="61" y="35"/>
                      <a:pt x="61" y="33"/>
                    </a:cubicBezTo>
                    <a:cubicBezTo>
                      <a:pt x="60" y="31"/>
                      <a:pt x="62" y="29"/>
                      <a:pt x="64" y="29"/>
                    </a:cubicBezTo>
                    <a:cubicBezTo>
                      <a:pt x="64" y="29"/>
                      <a:pt x="65" y="28"/>
                      <a:pt x="66" y="28"/>
                    </a:cubicBezTo>
                    <a:cubicBezTo>
                      <a:pt x="69" y="28"/>
                      <a:pt x="74" y="28"/>
                      <a:pt x="79" y="30"/>
                    </a:cubicBezTo>
                    <a:cubicBezTo>
                      <a:pt x="85" y="32"/>
                      <a:pt x="90" y="37"/>
                      <a:pt x="94" y="45"/>
                    </a:cubicBezTo>
                    <a:cubicBezTo>
                      <a:pt x="95" y="47"/>
                      <a:pt x="94" y="49"/>
                      <a:pt x="92" y="50"/>
                    </a:cubicBezTo>
                    <a:close/>
                    <a:moveTo>
                      <a:pt x="89" y="58"/>
                    </a:moveTo>
                    <a:cubicBezTo>
                      <a:pt x="88" y="55"/>
                      <a:pt x="90" y="54"/>
                      <a:pt x="92" y="53"/>
                    </a:cubicBezTo>
                    <a:cubicBezTo>
                      <a:pt x="94" y="53"/>
                      <a:pt x="96" y="55"/>
                      <a:pt x="96" y="57"/>
                    </a:cubicBezTo>
                    <a:cubicBezTo>
                      <a:pt x="97" y="59"/>
                      <a:pt x="95" y="61"/>
                      <a:pt x="93" y="61"/>
                    </a:cubicBezTo>
                    <a:cubicBezTo>
                      <a:pt x="91" y="61"/>
                      <a:pt x="89" y="60"/>
                      <a:pt x="89" y="58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8F1D5C01-2497-B0D3-CF01-05979EAAB35B}"/>
                </a:ext>
              </a:extLst>
            </p:cNvPr>
            <p:cNvSpPr/>
            <p:nvPr/>
          </p:nvSpPr>
          <p:spPr>
            <a:xfrm>
              <a:off x="5451959" y="2060363"/>
              <a:ext cx="3319507" cy="2325230"/>
            </a:xfrm>
            <a:prstGeom prst="rect">
              <a:avLst/>
            </a:prstGeom>
            <a:noFill/>
            <a:ln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4BB30391-FEE3-072B-6E3F-0F897C000197}"/>
                </a:ext>
              </a:extLst>
            </p:cNvPr>
            <p:cNvGrpSpPr/>
            <p:nvPr/>
          </p:nvGrpSpPr>
          <p:grpSpPr>
            <a:xfrm>
              <a:off x="6060890" y="3045915"/>
              <a:ext cx="445206" cy="417689"/>
              <a:chOff x="3968750" y="5791200"/>
              <a:chExt cx="762000" cy="762000"/>
            </a:xfrm>
          </p:grpSpPr>
          <p:sp>
            <p:nvSpPr>
              <p:cNvPr id="24" name="Oval 38">
                <a:extLst>
                  <a:ext uri="{FF2B5EF4-FFF2-40B4-BE49-F238E27FC236}">
                    <a16:creationId xmlns:a16="http://schemas.microsoft.com/office/drawing/2014/main" id="{54D94521-8E7C-37A5-318D-12B193EB89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8750" y="57912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Freeform 106">
                <a:extLst>
                  <a:ext uri="{FF2B5EF4-FFF2-40B4-BE49-F238E27FC236}">
                    <a16:creationId xmlns:a16="http://schemas.microsoft.com/office/drawing/2014/main" id="{D0AA6518-80E0-C119-076D-F45E4F3B0F1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127500" y="5984875"/>
                <a:ext cx="444500" cy="377825"/>
              </a:xfrm>
              <a:custGeom>
                <a:avLst/>
                <a:gdLst>
                  <a:gd name="T0" fmla="*/ 280 w 280"/>
                  <a:gd name="T1" fmla="*/ 86 h 238"/>
                  <a:gd name="T2" fmla="*/ 258 w 280"/>
                  <a:gd name="T3" fmla="*/ 238 h 238"/>
                  <a:gd name="T4" fmla="*/ 22 w 280"/>
                  <a:gd name="T5" fmla="*/ 238 h 238"/>
                  <a:gd name="T6" fmla="*/ 0 w 280"/>
                  <a:gd name="T7" fmla="*/ 86 h 238"/>
                  <a:gd name="T8" fmla="*/ 280 w 280"/>
                  <a:gd name="T9" fmla="*/ 86 h 238"/>
                  <a:gd name="T10" fmla="*/ 258 w 280"/>
                  <a:gd name="T11" fmla="*/ 44 h 238"/>
                  <a:gd name="T12" fmla="*/ 130 w 280"/>
                  <a:gd name="T13" fmla="*/ 44 h 238"/>
                  <a:gd name="T14" fmla="*/ 86 w 280"/>
                  <a:gd name="T15" fmla="*/ 0 h 238"/>
                  <a:gd name="T16" fmla="*/ 22 w 280"/>
                  <a:gd name="T17" fmla="*/ 0 h 238"/>
                  <a:gd name="T18" fmla="*/ 22 w 280"/>
                  <a:gd name="T19" fmla="*/ 44 h 238"/>
                  <a:gd name="T20" fmla="*/ 22 w 280"/>
                  <a:gd name="T21" fmla="*/ 64 h 238"/>
                  <a:gd name="T22" fmla="*/ 258 w 280"/>
                  <a:gd name="T23" fmla="*/ 64 h 238"/>
                  <a:gd name="T24" fmla="*/ 258 w 280"/>
                  <a:gd name="T25" fmla="*/ 44 h 2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</a:cxnLst>
                <a:rect l="0" t="0" r="r" b="b"/>
                <a:pathLst>
                  <a:path w="280" h="238">
                    <a:moveTo>
                      <a:pt x="280" y="86"/>
                    </a:moveTo>
                    <a:lnTo>
                      <a:pt x="258" y="238"/>
                    </a:lnTo>
                    <a:lnTo>
                      <a:pt x="22" y="238"/>
                    </a:lnTo>
                    <a:lnTo>
                      <a:pt x="0" y="86"/>
                    </a:lnTo>
                    <a:lnTo>
                      <a:pt x="280" y="86"/>
                    </a:lnTo>
                    <a:close/>
                    <a:moveTo>
                      <a:pt x="258" y="44"/>
                    </a:moveTo>
                    <a:lnTo>
                      <a:pt x="130" y="44"/>
                    </a:lnTo>
                    <a:lnTo>
                      <a:pt x="86" y="0"/>
                    </a:lnTo>
                    <a:lnTo>
                      <a:pt x="22" y="0"/>
                    </a:lnTo>
                    <a:lnTo>
                      <a:pt x="22" y="44"/>
                    </a:lnTo>
                    <a:lnTo>
                      <a:pt x="22" y="64"/>
                    </a:lnTo>
                    <a:lnTo>
                      <a:pt x="258" y="64"/>
                    </a:lnTo>
                    <a:lnTo>
                      <a:pt x="258" y="44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FE0691C3-A4B8-AA54-1E69-F3E06C08B0C0}"/>
                </a:ext>
              </a:extLst>
            </p:cNvPr>
            <p:cNvSpPr/>
            <p:nvPr/>
          </p:nvSpPr>
          <p:spPr>
            <a:xfrm>
              <a:off x="5451959" y="1190456"/>
              <a:ext cx="3248028" cy="643771"/>
            </a:xfrm>
            <a:prstGeom prst="rect">
              <a:avLst/>
            </a:prstGeom>
            <a:noFill/>
            <a:ln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AC73EC57-6B21-3C80-4794-5917E85F1BAB}"/>
                </a:ext>
              </a:extLst>
            </p:cNvPr>
            <p:cNvSpPr/>
            <p:nvPr/>
          </p:nvSpPr>
          <p:spPr>
            <a:xfrm>
              <a:off x="5495106" y="4667850"/>
              <a:ext cx="3167732" cy="549001"/>
            </a:xfrm>
            <a:prstGeom prst="rect">
              <a:avLst/>
            </a:prstGeom>
            <a:noFill/>
            <a:ln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箭头: 左右 30">
              <a:extLst>
                <a:ext uri="{FF2B5EF4-FFF2-40B4-BE49-F238E27FC236}">
                  <a16:creationId xmlns:a16="http://schemas.microsoft.com/office/drawing/2014/main" id="{9E03C4A7-77E3-8DEF-28B1-6758BF508273}"/>
                </a:ext>
              </a:extLst>
            </p:cNvPr>
            <p:cNvSpPr/>
            <p:nvPr/>
          </p:nvSpPr>
          <p:spPr>
            <a:xfrm>
              <a:off x="5038901" y="3132594"/>
              <a:ext cx="262819" cy="122166"/>
            </a:xfrm>
            <a:prstGeom prst="leftRightArrow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箭头: 左右 31">
              <a:extLst>
                <a:ext uri="{FF2B5EF4-FFF2-40B4-BE49-F238E27FC236}">
                  <a16:creationId xmlns:a16="http://schemas.microsoft.com/office/drawing/2014/main" id="{A761EA04-62C5-6471-B2E2-93F79836440B}"/>
                </a:ext>
              </a:extLst>
            </p:cNvPr>
            <p:cNvSpPr/>
            <p:nvPr/>
          </p:nvSpPr>
          <p:spPr>
            <a:xfrm>
              <a:off x="5083845" y="1416983"/>
              <a:ext cx="262819" cy="122166"/>
            </a:xfrm>
            <a:prstGeom prst="leftRightArrow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箭头: 左右 32">
              <a:extLst>
                <a:ext uri="{FF2B5EF4-FFF2-40B4-BE49-F238E27FC236}">
                  <a16:creationId xmlns:a16="http://schemas.microsoft.com/office/drawing/2014/main" id="{0BEFA56A-EE30-0B09-CCC9-80DBD6C08A2F}"/>
                </a:ext>
              </a:extLst>
            </p:cNvPr>
            <p:cNvSpPr/>
            <p:nvPr/>
          </p:nvSpPr>
          <p:spPr>
            <a:xfrm>
              <a:off x="5111254" y="4915907"/>
              <a:ext cx="262819" cy="122166"/>
            </a:xfrm>
            <a:prstGeom prst="leftRightArrow">
              <a:avLst/>
            </a:prstGeom>
            <a:solidFill>
              <a:schemeClr val="accent4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1B432946-EB6E-6E2C-4103-C576722CD4A9}"/>
                </a:ext>
              </a:extLst>
            </p:cNvPr>
            <p:cNvSpPr/>
            <p:nvPr/>
          </p:nvSpPr>
          <p:spPr>
            <a:xfrm>
              <a:off x="5587397" y="1356652"/>
              <a:ext cx="1389135" cy="319267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1000" b="0" i="0" u="none" strike="noStrike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sk decomposition inference engin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AC273804-596A-DA85-2C76-9EF8AF6F2B67}"/>
                </a:ext>
              </a:extLst>
            </p:cNvPr>
            <p:cNvSpPr/>
            <p:nvPr/>
          </p:nvSpPr>
          <p:spPr>
            <a:xfrm>
              <a:off x="7193108" y="1363550"/>
              <a:ext cx="1469730" cy="312370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sk decomposition knowledge bas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91295CBD-0905-8F7B-BA3A-1722A4A37431}"/>
                </a:ext>
              </a:extLst>
            </p:cNvPr>
            <p:cNvSpPr/>
            <p:nvPr/>
          </p:nvSpPr>
          <p:spPr>
            <a:xfrm>
              <a:off x="7355413" y="4807242"/>
              <a:ext cx="1145119" cy="288062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gotiation knowledge bas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B98F0989-0AD9-A4C2-0991-45997BE73B99}"/>
                </a:ext>
              </a:extLst>
            </p:cNvPr>
            <p:cNvSpPr/>
            <p:nvPr/>
          </p:nvSpPr>
          <p:spPr>
            <a:xfrm>
              <a:off x="5668277" y="4804667"/>
              <a:ext cx="1181719" cy="288062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0" i="0" u="none" strike="noStrike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gotiation inference engine</a:t>
              </a:r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直接箭头连接符 38">
              <a:extLst>
                <a:ext uri="{FF2B5EF4-FFF2-40B4-BE49-F238E27FC236}">
                  <a16:creationId xmlns:a16="http://schemas.microsoft.com/office/drawing/2014/main" id="{9F9056E1-F555-44D8-4984-89A4E8705088}"/>
                </a:ext>
              </a:extLst>
            </p:cNvPr>
            <p:cNvCxnSpPr>
              <a:cxnSpLocks/>
              <a:stCxn id="34" idx="3"/>
              <a:endCxn id="35" idx="1"/>
            </p:cNvCxnSpPr>
            <p:nvPr/>
          </p:nvCxnSpPr>
          <p:spPr>
            <a:xfrm>
              <a:off x="6976532" y="1516286"/>
              <a:ext cx="216576" cy="3449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箭头连接符 40">
              <a:extLst>
                <a:ext uri="{FF2B5EF4-FFF2-40B4-BE49-F238E27FC236}">
                  <a16:creationId xmlns:a16="http://schemas.microsoft.com/office/drawing/2014/main" id="{C3ED21AC-5D07-D02C-8415-A011998D7EB1}"/>
                </a:ext>
              </a:extLst>
            </p:cNvPr>
            <p:cNvCxnSpPr>
              <a:cxnSpLocks/>
              <a:stCxn id="37" idx="3"/>
              <a:endCxn id="36" idx="1"/>
            </p:cNvCxnSpPr>
            <p:nvPr/>
          </p:nvCxnSpPr>
          <p:spPr>
            <a:xfrm>
              <a:off x="6849996" y="4948698"/>
              <a:ext cx="505417" cy="2575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箭头连接符 42">
              <a:extLst>
                <a:ext uri="{FF2B5EF4-FFF2-40B4-BE49-F238E27FC236}">
                  <a16:creationId xmlns:a16="http://schemas.microsoft.com/office/drawing/2014/main" id="{1511CF32-4852-0480-2629-30A005AE67B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283493" y="2809691"/>
              <a:ext cx="2" cy="202357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箭头连接符 44">
              <a:extLst>
                <a:ext uri="{FF2B5EF4-FFF2-40B4-BE49-F238E27FC236}">
                  <a16:creationId xmlns:a16="http://schemas.microsoft.com/office/drawing/2014/main" id="{79A884D1-A3FE-6C2F-A0DF-2FA2793F1A0C}"/>
                </a:ext>
              </a:extLst>
            </p:cNvPr>
            <p:cNvCxnSpPr/>
            <p:nvPr/>
          </p:nvCxnSpPr>
          <p:spPr>
            <a:xfrm flipH="1">
              <a:off x="6283489" y="3480853"/>
              <a:ext cx="2" cy="202357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6290BC3F-3C9D-0F50-494C-91C2D5FB7AC2}"/>
                </a:ext>
              </a:extLst>
            </p:cNvPr>
            <p:cNvGrpSpPr/>
            <p:nvPr/>
          </p:nvGrpSpPr>
          <p:grpSpPr>
            <a:xfrm>
              <a:off x="5997387" y="2166695"/>
              <a:ext cx="594781" cy="601204"/>
              <a:chOff x="5786438" y="5791200"/>
              <a:chExt cx="762000" cy="762000"/>
            </a:xfrm>
          </p:grpSpPr>
          <p:sp>
            <p:nvSpPr>
              <p:cNvPr id="46" name="Oval 30">
                <a:extLst>
                  <a:ext uri="{FF2B5EF4-FFF2-40B4-BE49-F238E27FC236}">
                    <a16:creationId xmlns:a16="http://schemas.microsoft.com/office/drawing/2014/main" id="{FBDE6BFA-5856-8D7D-E7CB-2A8319B696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438" y="57912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Freeform 98">
                <a:extLst>
                  <a:ext uri="{FF2B5EF4-FFF2-40B4-BE49-F238E27FC236}">
                    <a16:creationId xmlns:a16="http://schemas.microsoft.com/office/drawing/2014/main" id="{0C0AFEB8-F04A-3169-8F4D-3D8576EC1B3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957888" y="5972175"/>
                <a:ext cx="419100" cy="400050"/>
              </a:xfrm>
              <a:custGeom>
                <a:avLst/>
                <a:gdLst>
                  <a:gd name="T0" fmla="*/ 5 w 132"/>
                  <a:gd name="T1" fmla="*/ 1 h 126"/>
                  <a:gd name="T2" fmla="*/ 0 w 132"/>
                  <a:gd name="T3" fmla="*/ 118 h 126"/>
                  <a:gd name="T4" fmla="*/ 31 w 132"/>
                  <a:gd name="T5" fmla="*/ 123 h 126"/>
                  <a:gd name="T6" fmla="*/ 36 w 132"/>
                  <a:gd name="T7" fmla="*/ 6 h 126"/>
                  <a:gd name="T8" fmla="*/ 18 w 132"/>
                  <a:gd name="T9" fmla="*/ 113 h 126"/>
                  <a:gd name="T10" fmla="*/ 18 w 132"/>
                  <a:gd name="T11" fmla="*/ 93 h 126"/>
                  <a:gd name="T12" fmla="*/ 18 w 132"/>
                  <a:gd name="T13" fmla="*/ 113 h 126"/>
                  <a:gd name="T14" fmla="*/ 27 w 132"/>
                  <a:gd name="T15" fmla="*/ 70 h 126"/>
                  <a:gd name="T16" fmla="*/ 5 w 132"/>
                  <a:gd name="T17" fmla="*/ 66 h 126"/>
                  <a:gd name="T18" fmla="*/ 9 w 132"/>
                  <a:gd name="T19" fmla="*/ 10 h 126"/>
                  <a:gd name="T20" fmla="*/ 31 w 132"/>
                  <a:gd name="T21" fmla="*/ 14 h 126"/>
                  <a:gd name="T22" fmla="*/ 24 w 132"/>
                  <a:gd name="T23" fmla="*/ 103 h 126"/>
                  <a:gd name="T24" fmla="*/ 11 w 132"/>
                  <a:gd name="T25" fmla="*/ 103 h 126"/>
                  <a:gd name="T26" fmla="*/ 24 w 132"/>
                  <a:gd name="T27" fmla="*/ 103 h 126"/>
                  <a:gd name="T28" fmla="*/ 30 w 132"/>
                  <a:gd name="T29" fmla="*/ 15 h 126"/>
                  <a:gd name="T30" fmla="*/ 6 w 132"/>
                  <a:gd name="T31" fmla="*/ 23 h 126"/>
                  <a:gd name="T32" fmla="*/ 43 w 132"/>
                  <a:gd name="T33" fmla="*/ 15 h 126"/>
                  <a:gd name="T34" fmla="*/ 67 w 132"/>
                  <a:gd name="T35" fmla="*/ 23 h 126"/>
                  <a:gd name="T36" fmla="*/ 43 w 132"/>
                  <a:gd name="T37" fmla="*/ 15 h 126"/>
                  <a:gd name="T38" fmla="*/ 55 w 132"/>
                  <a:gd name="T39" fmla="*/ 110 h 126"/>
                  <a:gd name="T40" fmla="*/ 55 w 132"/>
                  <a:gd name="T41" fmla="*/ 96 h 126"/>
                  <a:gd name="T42" fmla="*/ 68 w 132"/>
                  <a:gd name="T43" fmla="*/ 1 h 126"/>
                  <a:gd name="T44" fmla="*/ 37 w 132"/>
                  <a:gd name="T45" fmla="*/ 6 h 126"/>
                  <a:gd name="T46" fmla="*/ 43 w 132"/>
                  <a:gd name="T47" fmla="*/ 123 h 126"/>
                  <a:gd name="T48" fmla="*/ 73 w 132"/>
                  <a:gd name="T49" fmla="*/ 118 h 126"/>
                  <a:gd name="T50" fmla="*/ 68 w 132"/>
                  <a:gd name="T51" fmla="*/ 1 h 126"/>
                  <a:gd name="T52" fmla="*/ 45 w 132"/>
                  <a:gd name="T53" fmla="*/ 103 h 126"/>
                  <a:gd name="T54" fmla="*/ 65 w 132"/>
                  <a:gd name="T55" fmla="*/ 103 h 126"/>
                  <a:gd name="T56" fmla="*/ 68 w 132"/>
                  <a:gd name="T57" fmla="*/ 66 h 126"/>
                  <a:gd name="T58" fmla="*/ 46 w 132"/>
                  <a:gd name="T59" fmla="*/ 70 h 126"/>
                  <a:gd name="T60" fmla="*/ 42 w 132"/>
                  <a:gd name="T61" fmla="*/ 14 h 126"/>
                  <a:gd name="T62" fmla="*/ 64 w 132"/>
                  <a:gd name="T63" fmla="*/ 10 h 126"/>
                  <a:gd name="T64" fmla="*/ 68 w 132"/>
                  <a:gd name="T65" fmla="*/ 66 h 126"/>
                  <a:gd name="T66" fmla="*/ 102 w 132"/>
                  <a:gd name="T67" fmla="*/ 1 h 126"/>
                  <a:gd name="T68" fmla="*/ 75 w 132"/>
                  <a:gd name="T69" fmla="*/ 115 h 126"/>
                  <a:gd name="T70" fmla="*/ 104 w 132"/>
                  <a:gd name="T71" fmla="*/ 126 h 126"/>
                  <a:gd name="T72" fmla="*/ 132 w 132"/>
                  <a:gd name="T73" fmla="*/ 12 h 126"/>
                  <a:gd name="T74" fmla="*/ 105 w 132"/>
                  <a:gd name="T75" fmla="*/ 105 h 126"/>
                  <a:gd name="T76" fmla="*/ 85 w 132"/>
                  <a:gd name="T77" fmla="*/ 102 h 126"/>
                  <a:gd name="T78" fmla="*/ 105 w 132"/>
                  <a:gd name="T79" fmla="*/ 105 h 126"/>
                  <a:gd name="T80" fmla="*/ 110 w 132"/>
                  <a:gd name="T81" fmla="*/ 73 h 126"/>
                  <a:gd name="T82" fmla="*/ 90 w 132"/>
                  <a:gd name="T83" fmla="*/ 65 h 126"/>
                  <a:gd name="T84" fmla="*/ 104 w 132"/>
                  <a:gd name="T85" fmla="*/ 11 h 126"/>
                  <a:gd name="T86" fmla="*/ 125 w 132"/>
                  <a:gd name="T87" fmla="*/ 19 h 126"/>
                  <a:gd name="T88" fmla="*/ 102 w 132"/>
                  <a:gd name="T89" fmla="*/ 105 h 126"/>
                  <a:gd name="T90" fmla="*/ 89 w 132"/>
                  <a:gd name="T91" fmla="*/ 102 h 126"/>
                  <a:gd name="T92" fmla="*/ 102 w 132"/>
                  <a:gd name="T93" fmla="*/ 105 h 126"/>
                  <a:gd name="T94" fmla="*/ 124 w 132"/>
                  <a:gd name="T95" fmla="*/ 19 h 126"/>
                  <a:gd name="T96" fmla="*/ 99 w 132"/>
                  <a:gd name="T97" fmla="*/ 23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</a:cxnLst>
                <a:rect l="0" t="0" r="r" b="b"/>
                <a:pathLst>
                  <a:path w="132" h="126">
                    <a:moveTo>
                      <a:pt x="31" y="1"/>
                    </a:moveTo>
                    <a:cubicBezTo>
                      <a:pt x="5" y="1"/>
                      <a:pt x="5" y="1"/>
                      <a:pt x="5" y="1"/>
                    </a:cubicBezTo>
                    <a:cubicBezTo>
                      <a:pt x="2" y="1"/>
                      <a:pt x="0" y="3"/>
                      <a:pt x="0" y="6"/>
                    </a:cubicBezTo>
                    <a:cubicBezTo>
                      <a:pt x="0" y="118"/>
                      <a:pt x="0" y="118"/>
                      <a:pt x="0" y="118"/>
                    </a:cubicBezTo>
                    <a:cubicBezTo>
                      <a:pt x="0" y="121"/>
                      <a:pt x="2" y="123"/>
                      <a:pt x="5" y="123"/>
                    </a:cubicBezTo>
                    <a:cubicBezTo>
                      <a:pt x="31" y="123"/>
                      <a:pt x="31" y="123"/>
                      <a:pt x="31" y="123"/>
                    </a:cubicBezTo>
                    <a:cubicBezTo>
                      <a:pt x="33" y="123"/>
                      <a:pt x="36" y="121"/>
                      <a:pt x="36" y="118"/>
                    </a:cubicBezTo>
                    <a:cubicBezTo>
                      <a:pt x="36" y="6"/>
                      <a:pt x="36" y="6"/>
                      <a:pt x="36" y="6"/>
                    </a:cubicBezTo>
                    <a:cubicBezTo>
                      <a:pt x="36" y="3"/>
                      <a:pt x="33" y="1"/>
                      <a:pt x="31" y="1"/>
                    </a:cubicBezTo>
                    <a:close/>
                    <a:moveTo>
                      <a:pt x="18" y="113"/>
                    </a:moveTo>
                    <a:cubicBezTo>
                      <a:pt x="12" y="113"/>
                      <a:pt x="8" y="108"/>
                      <a:pt x="8" y="103"/>
                    </a:cubicBezTo>
                    <a:cubicBezTo>
                      <a:pt x="8" y="97"/>
                      <a:pt x="12" y="93"/>
                      <a:pt x="18" y="93"/>
                    </a:cubicBezTo>
                    <a:cubicBezTo>
                      <a:pt x="23" y="93"/>
                      <a:pt x="28" y="97"/>
                      <a:pt x="28" y="103"/>
                    </a:cubicBezTo>
                    <a:cubicBezTo>
                      <a:pt x="28" y="108"/>
                      <a:pt x="23" y="113"/>
                      <a:pt x="18" y="113"/>
                    </a:cubicBezTo>
                    <a:close/>
                    <a:moveTo>
                      <a:pt x="31" y="66"/>
                    </a:moveTo>
                    <a:cubicBezTo>
                      <a:pt x="31" y="68"/>
                      <a:pt x="29" y="70"/>
                      <a:pt x="27" y="70"/>
                    </a:cubicBezTo>
                    <a:cubicBezTo>
                      <a:pt x="9" y="70"/>
                      <a:pt x="9" y="70"/>
                      <a:pt x="9" y="70"/>
                    </a:cubicBezTo>
                    <a:cubicBezTo>
                      <a:pt x="7" y="70"/>
                      <a:pt x="5" y="68"/>
                      <a:pt x="5" y="66"/>
                    </a:cubicBezTo>
                    <a:cubicBezTo>
                      <a:pt x="5" y="14"/>
                      <a:pt x="5" y="14"/>
                      <a:pt x="5" y="14"/>
                    </a:cubicBezTo>
                    <a:cubicBezTo>
                      <a:pt x="5" y="12"/>
                      <a:pt x="7" y="10"/>
                      <a:pt x="9" y="10"/>
                    </a:cubicBezTo>
                    <a:cubicBezTo>
                      <a:pt x="27" y="10"/>
                      <a:pt x="27" y="10"/>
                      <a:pt x="27" y="10"/>
                    </a:cubicBezTo>
                    <a:cubicBezTo>
                      <a:pt x="29" y="10"/>
                      <a:pt x="31" y="12"/>
                      <a:pt x="31" y="14"/>
                    </a:cubicBezTo>
                    <a:lnTo>
                      <a:pt x="31" y="66"/>
                    </a:lnTo>
                    <a:close/>
                    <a:moveTo>
                      <a:pt x="24" y="103"/>
                    </a:moveTo>
                    <a:cubicBezTo>
                      <a:pt x="24" y="107"/>
                      <a:pt x="21" y="110"/>
                      <a:pt x="18" y="110"/>
                    </a:cubicBezTo>
                    <a:cubicBezTo>
                      <a:pt x="14" y="110"/>
                      <a:pt x="11" y="107"/>
                      <a:pt x="11" y="103"/>
                    </a:cubicBezTo>
                    <a:cubicBezTo>
                      <a:pt x="11" y="99"/>
                      <a:pt x="14" y="96"/>
                      <a:pt x="18" y="96"/>
                    </a:cubicBezTo>
                    <a:cubicBezTo>
                      <a:pt x="21" y="96"/>
                      <a:pt x="24" y="99"/>
                      <a:pt x="24" y="103"/>
                    </a:cubicBezTo>
                    <a:close/>
                    <a:moveTo>
                      <a:pt x="6" y="15"/>
                    </a:moveTo>
                    <a:cubicBezTo>
                      <a:pt x="30" y="15"/>
                      <a:pt x="30" y="15"/>
                      <a:pt x="30" y="15"/>
                    </a:cubicBezTo>
                    <a:cubicBezTo>
                      <a:pt x="30" y="23"/>
                      <a:pt x="30" y="23"/>
                      <a:pt x="30" y="23"/>
                    </a:cubicBezTo>
                    <a:cubicBezTo>
                      <a:pt x="6" y="23"/>
                      <a:pt x="6" y="23"/>
                      <a:pt x="6" y="23"/>
                    </a:cubicBezTo>
                    <a:lnTo>
                      <a:pt x="6" y="15"/>
                    </a:lnTo>
                    <a:close/>
                    <a:moveTo>
                      <a:pt x="43" y="15"/>
                    </a:moveTo>
                    <a:cubicBezTo>
                      <a:pt x="67" y="15"/>
                      <a:pt x="67" y="15"/>
                      <a:pt x="67" y="15"/>
                    </a:cubicBezTo>
                    <a:cubicBezTo>
                      <a:pt x="67" y="23"/>
                      <a:pt x="67" y="23"/>
                      <a:pt x="67" y="23"/>
                    </a:cubicBezTo>
                    <a:cubicBezTo>
                      <a:pt x="43" y="23"/>
                      <a:pt x="43" y="23"/>
                      <a:pt x="43" y="23"/>
                    </a:cubicBezTo>
                    <a:lnTo>
                      <a:pt x="43" y="15"/>
                    </a:lnTo>
                    <a:close/>
                    <a:moveTo>
                      <a:pt x="62" y="103"/>
                    </a:moveTo>
                    <a:cubicBezTo>
                      <a:pt x="62" y="107"/>
                      <a:pt x="59" y="110"/>
                      <a:pt x="55" y="110"/>
                    </a:cubicBezTo>
                    <a:cubicBezTo>
                      <a:pt x="51" y="110"/>
                      <a:pt x="48" y="107"/>
                      <a:pt x="48" y="103"/>
                    </a:cubicBezTo>
                    <a:cubicBezTo>
                      <a:pt x="48" y="99"/>
                      <a:pt x="51" y="96"/>
                      <a:pt x="55" y="96"/>
                    </a:cubicBezTo>
                    <a:cubicBezTo>
                      <a:pt x="59" y="96"/>
                      <a:pt x="62" y="99"/>
                      <a:pt x="62" y="103"/>
                    </a:cubicBezTo>
                    <a:close/>
                    <a:moveTo>
                      <a:pt x="68" y="1"/>
                    </a:moveTo>
                    <a:cubicBezTo>
                      <a:pt x="43" y="1"/>
                      <a:pt x="43" y="1"/>
                      <a:pt x="43" y="1"/>
                    </a:cubicBezTo>
                    <a:cubicBezTo>
                      <a:pt x="40" y="1"/>
                      <a:pt x="37" y="3"/>
                      <a:pt x="37" y="6"/>
                    </a:cubicBezTo>
                    <a:cubicBezTo>
                      <a:pt x="37" y="118"/>
                      <a:pt x="37" y="118"/>
                      <a:pt x="37" y="118"/>
                    </a:cubicBezTo>
                    <a:cubicBezTo>
                      <a:pt x="37" y="121"/>
                      <a:pt x="40" y="123"/>
                      <a:pt x="43" y="123"/>
                    </a:cubicBezTo>
                    <a:cubicBezTo>
                      <a:pt x="68" y="123"/>
                      <a:pt x="68" y="123"/>
                      <a:pt x="68" y="123"/>
                    </a:cubicBezTo>
                    <a:cubicBezTo>
                      <a:pt x="71" y="123"/>
                      <a:pt x="73" y="121"/>
                      <a:pt x="73" y="118"/>
                    </a:cubicBezTo>
                    <a:cubicBezTo>
                      <a:pt x="73" y="6"/>
                      <a:pt x="73" y="6"/>
                      <a:pt x="73" y="6"/>
                    </a:cubicBezTo>
                    <a:cubicBezTo>
                      <a:pt x="73" y="3"/>
                      <a:pt x="71" y="1"/>
                      <a:pt x="68" y="1"/>
                    </a:cubicBezTo>
                    <a:close/>
                    <a:moveTo>
                      <a:pt x="55" y="113"/>
                    </a:moveTo>
                    <a:cubicBezTo>
                      <a:pt x="50" y="113"/>
                      <a:pt x="45" y="108"/>
                      <a:pt x="45" y="103"/>
                    </a:cubicBezTo>
                    <a:cubicBezTo>
                      <a:pt x="45" y="97"/>
                      <a:pt x="50" y="93"/>
                      <a:pt x="55" y="93"/>
                    </a:cubicBezTo>
                    <a:cubicBezTo>
                      <a:pt x="61" y="93"/>
                      <a:pt x="65" y="97"/>
                      <a:pt x="65" y="103"/>
                    </a:cubicBezTo>
                    <a:cubicBezTo>
                      <a:pt x="65" y="108"/>
                      <a:pt x="61" y="113"/>
                      <a:pt x="55" y="113"/>
                    </a:cubicBezTo>
                    <a:close/>
                    <a:moveTo>
                      <a:pt x="68" y="66"/>
                    </a:moveTo>
                    <a:cubicBezTo>
                      <a:pt x="68" y="68"/>
                      <a:pt x="67" y="70"/>
                      <a:pt x="64" y="70"/>
                    </a:cubicBezTo>
                    <a:cubicBezTo>
                      <a:pt x="46" y="70"/>
                      <a:pt x="46" y="70"/>
                      <a:pt x="46" y="70"/>
                    </a:cubicBezTo>
                    <a:cubicBezTo>
                      <a:pt x="44" y="70"/>
                      <a:pt x="42" y="68"/>
                      <a:pt x="42" y="66"/>
                    </a:cubicBezTo>
                    <a:cubicBezTo>
                      <a:pt x="42" y="14"/>
                      <a:pt x="42" y="14"/>
                      <a:pt x="42" y="14"/>
                    </a:cubicBezTo>
                    <a:cubicBezTo>
                      <a:pt x="42" y="12"/>
                      <a:pt x="44" y="10"/>
                      <a:pt x="46" y="10"/>
                    </a:cubicBezTo>
                    <a:cubicBezTo>
                      <a:pt x="64" y="10"/>
                      <a:pt x="64" y="10"/>
                      <a:pt x="64" y="10"/>
                    </a:cubicBezTo>
                    <a:cubicBezTo>
                      <a:pt x="67" y="10"/>
                      <a:pt x="68" y="12"/>
                      <a:pt x="68" y="14"/>
                    </a:cubicBezTo>
                    <a:lnTo>
                      <a:pt x="68" y="66"/>
                    </a:lnTo>
                    <a:close/>
                    <a:moveTo>
                      <a:pt x="127" y="6"/>
                    </a:moveTo>
                    <a:cubicBezTo>
                      <a:pt x="102" y="1"/>
                      <a:pt x="102" y="1"/>
                      <a:pt x="102" y="1"/>
                    </a:cubicBezTo>
                    <a:cubicBezTo>
                      <a:pt x="99" y="0"/>
                      <a:pt x="97" y="2"/>
                      <a:pt x="96" y="5"/>
                    </a:cubicBezTo>
                    <a:cubicBezTo>
                      <a:pt x="75" y="115"/>
                      <a:pt x="75" y="115"/>
                      <a:pt x="75" y="115"/>
                    </a:cubicBezTo>
                    <a:cubicBezTo>
                      <a:pt x="74" y="118"/>
                      <a:pt x="76" y="120"/>
                      <a:pt x="79" y="121"/>
                    </a:cubicBezTo>
                    <a:cubicBezTo>
                      <a:pt x="104" y="126"/>
                      <a:pt x="104" y="126"/>
                      <a:pt x="104" y="126"/>
                    </a:cubicBezTo>
                    <a:cubicBezTo>
                      <a:pt x="107" y="126"/>
                      <a:pt x="110" y="124"/>
                      <a:pt x="110" y="122"/>
                    </a:cubicBezTo>
                    <a:cubicBezTo>
                      <a:pt x="132" y="12"/>
                      <a:pt x="132" y="12"/>
                      <a:pt x="132" y="12"/>
                    </a:cubicBezTo>
                    <a:cubicBezTo>
                      <a:pt x="132" y="9"/>
                      <a:pt x="130" y="6"/>
                      <a:pt x="127" y="6"/>
                    </a:cubicBezTo>
                    <a:close/>
                    <a:moveTo>
                      <a:pt x="105" y="105"/>
                    </a:moveTo>
                    <a:cubicBezTo>
                      <a:pt x="104" y="111"/>
                      <a:pt x="99" y="114"/>
                      <a:pt x="93" y="113"/>
                    </a:cubicBezTo>
                    <a:cubicBezTo>
                      <a:pt x="88" y="112"/>
                      <a:pt x="84" y="107"/>
                      <a:pt x="85" y="102"/>
                    </a:cubicBezTo>
                    <a:cubicBezTo>
                      <a:pt x="86" y="96"/>
                      <a:pt x="92" y="93"/>
                      <a:pt x="97" y="94"/>
                    </a:cubicBezTo>
                    <a:cubicBezTo>
                      <a:pt x="103" y="95"/>
                      <a:pt x="106" y="100"/>
                      <a:pt x="105" y="105"/>
                    </a:cubicBezTo>
                    <a:close/>
                    <a:moveTo>
                      <a:pt x="115" y="70"/>
                    </a:moveTo>
                    <a:cubicBezTo>
                      <a:pt x="115" y="72"/>
                      <a:pt x="113" y="74"/>
                      <a:pt x="110" y="73"/>
                    </a:cubicBezTo>
                    <a:cubicBezTo>
                      <a:pt x="93" y="70"/>
                      <a:pt x="93" y="70"/>
                      <a:pt x="93" y="70"/>
                    </a:cubicBezTo>
                    <a:cubicBezTo>
                      <a:pt x="91" y="69"/>
                      <a:pt x="89" y="67"/>
                      <a:pt x="90" y="65"/>
                    </a:cubicBezTo>
                    <a:cubicBezTo>
                      <a:pt x="100" y="14"/>
                      <a:pt x="100" y="14"/>
                      <a:pt x="100" y="14"/>
                    </a:cubicBezTo>
                    <a:cubicBezTo>
                      <a:pt x="100" y="12"/>
                      <a:pt x="102" y="10"/>
                      <a:pt x="104" y="11"/>
                    </a:cubicBezTo>
                    <a:cubicBezTo>
                      <a:pt x="122" y="14"/>
                      <a:pt x="122" y="14"/>
                      <a:pt x="122" y="14"/>
                    </a:cubicBezTo>
                    <a:cubicBezTo>
                      <a:pt x="124" y="15"/>
                      <a:pt x="125" y="17"/>
                      <a:pt x="125" y="19"/>
                    </a:cubicBezTo>
                    <a:lnTo>
                      <a:pt x="115" y="70"/>
                    </a:lnTo>
                    <a:close/>
                    <a:moveTo>
                      <a:pt x="102" y="105"/>
                    </a:moveTo>
                    <a:cubicBezTo>
                      <a:pt x="101" y="108"/>
                      <a:pt x="98" y="111"/>
                      <a:pt x="94" y="110"/>
                    </a:cubicBezTo>
                    <a:cubicBezTo>
                      <a:pt x="90" y="109"/>
                      <a:pt x="88" y="106"/>
                      <a:pt x="89" y="102"/>
                    </a:cubicBezTo>
                    <a:cubicBezTo>
                      <a:pt x="89" y="99"/>
                      <a:pt x="93" y="96"/>
                      <a:pt x="97" y="97"/>
                    </a:cubicBezTo>
                    <a:cubicBezTo>
                      <a:pt x="100" y="98"/>
                      <a:pt x="102" y="101"/>
                      <a:pt x="102" y="105"/>
                    </a:cubicBezTo>
                    <a:close/>
                    <a:moveTo>
                      <a:pt x="100" y="15"/>
                    </a:moveTo>
                    <a:cubicBezTo>
                      <a:pt x="124" y="19"/>
                      <a:pt x="124" y="19"/>
                      <a:pt x="124" y="19"/>
                    </a:cubicBezTo>
                    <a:cubicBezTo>
                      <a:pt x="123" y="27"/>
                      <a:pt x="123" y="27"/>
                      <a:pt x="123" y="27"/>
                    </a:cubicBezTo>
                    <a:cubicBezTo>
                      <a:pt x="99" y="23"/>
                      <a:pt x="99" y="23"/>
                      <a:pt x="99" y="23"/>
                    </a:cubicBezTo>
                    <a:lnTo>
                      <a:pt x="100" y="15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92CA1E42-B23E-CC15-3C11-655DCCAD306A}"/>
                </a:ext>
              </a:extLst>
            </p:cNvPr>
            <p:cNvGrpSpPr/>
            <p:nvPr/>
          </p:nvGrpSpPr>
          <p:grpSpPr>
            <a:xfrm>
              <a:off x="5997389" y="3720360"/>
              <a:ext cx="594779" cy="585393"/>
              <a:chOff x="5786438" y="304800"/>
              <a:chExt cx="762000" cy="762000"/>
            </a:xfrm>
          </p:grpSpPr>
          <p:sp>
            <p:nvSpPr>
              <p:cNvPr id="50" name="Oval 56">
                <a:extLst>
                  <a:ext uri="{FF2B5EF4-FFF2-40B4-BE49-F238E27FC236}">
                    <a16:creationId xmlns:a16="http://schemas.microsoft.com/office/drawing/2014/main" id="{8992C64F-22D4-548A-1CE1-138928A766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6438" y="304800"/>
                <a:ext cx="762000" cy="762000"/>
              </a:xfrm>
              <a:prstGeom prst="ellipse">
                <a:avLst/>
              </a:prstGeom>
              <a:solidFill>
                <a:srgbClr val="4F5A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Freeform 124">
                <a:extLst>
                  <a:ext uri="{FF2B5EF4-FFF2-40B4-BE49-F238E27FC236}">
                    <a16:creationId xmlns:a16="http://schemas.microsoft.com/office/drawing/2014/main" id="{7131C873-AC73-9818-55B4-F841D2D7266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945188" y="463550"/>
                <a:ext cx="444500" cy="444500"/>
              </a:xfrm>
              <a:custGeom>
                <a:avLst/>
                <a:gdLst>
                  <a:gd name="T0" fmla="*/ 101 w 140"/>
                  <a:gd name="T1" fmla="*/ 21 h 140"/>
                  <a:gd name="T2" fmla="*/ 117 w 140"/>
                  <a:gd name="T3" fmla="*/ 5 h 140"/>
                  <a:gd name="T4" fmla="*/ 119 w 140"/>
                  <a:gd name="T5" fmla="*/ 6 h 140"/>
                  <a:gd name="T6" fmla="*/ 120 w 140"/>
                  <a:gd name="T7" fmla="*/ 20 h 140"/>
                  <a:gd name="T8" fmla="*/ 134 w 140"/>
                  <a:gd name="T9" fmla="*/ 22 h 140"/>
                  <a:gd name="T10" fmla="*/ 135 w 140"/>
                  <a:gd name="T11" fmla="*/ 24 h 140"/>
                  <a:gd name="T12" fmla="*/ 120 w 140"/>
                  <a:gd name="T13" fmla="*/ 39 h 140"/>
                  <a:gd name="T14" fmla="*/ 116 w 140"/>
                  <a:gd name="T15" fmla="*/ 40 h 140"/>
                  <a:gd name="T16" fmla="*/ 107 w 140"/>
                  <a:gd name="T17" fmla="*/ 39 h 140"/>
                  <a:gd name="T18" fmla="*/ 80 w 140"/>
                  <a:gd name="T19" fmla="*/ 66 h 140"/>
                  <a:gd name="T20" fmla="*/ 78 w 140"/>
                  <a:gd name="T21" fmla="*/ 79 h 140"/>
                  <a:gd name="T22" fmla="*/ 61 w 140"/>
                  <a:gd name="T23" fmla="*/ 79 h 140"/>
                  <a:gd name="T24" fmla="*/ 61 w 140"/>
                  <a:gd name="T25" fmla="*/ 62 h 140"/>
                  <a:gd name="T26" fmla="*/ 75 w 140"/>
                  <a:gd name="T27" fmla="*/ 60 h 140"/>
                  <a:gd name="T28" fmla="*/ 101 w 140"/>
                  <a:gd name="T29" fmla="*/ 34 h 140"/>
                  <a:gd name="T30" fmla="*/ 100 w 140"/>
                  <a:gd name="T31" fmla="*/ 25 h 140"/>
                  <a:gd name="T32" fmla="*/ 101 w 140"/>
                  <a:gd name="T33" fmla="*/ 21 h 140"/>
                  <a:gd name="T34" fmla="*/ 130 w 140"/>
                  <a:gd name="T35" fmla="*/ 34 h 140"/>
                  <a:gd name="T36" fmla="*/ 122 w 140"/>
                  <a:gd name="T37" fmla="*/ 42 h 140"/>
                  <a:gd name="T38" fmla="*/ 118 w 140"/>
                  <a:gd name="T39" fmla="*/ 44 h 140"/>
                  <a:gd name="T40" fmla="*/ 124 w 140"/>
                  <a:gd name="T41" fmla="*/ 70 h 140"/>
                  <a:gd name="T42" fmla="*/ 70 w 140"/>
                  <a:gd name="T43" fmla="*/ 125 h 140"/>
                  <a:gd name="T44" fmla="*/ 15 w 140"/>
                  <a:gd name="T45" fmla="*/ 70 h 140"/>
                  <a:gd name="T46" fmla="*/ 70 w 140"/>
                  <a:gd name="T47" fmla="*/ 16 h 140"/>
                  <a:gd name="T48" fmla="*/ 96 w 140"/>
                  <a:gd name="T49" fmla="*/ 23 h 140"/>
                  <a:gd name="T50" fmla="*/ 99 w 140"/>
                  <a:gd name="T51" fmla="*/ 18 h 140"/>
                  <a:gd name="T52" fmla="*/ 106 w 140"/>
                  <a:gd name="T53" fmla="*/ 11 h 140"/>
                  <a:gd name="T54" fmla="*/ 70 w 140"/>
                  <a:gd name="T55" fmla="*/ 0 h 140"/>
                  <a:gd name="T56" fmla="*/ 0 w 140"/>
                  <a:gd name="T57" fmla="*/ 70 h 140"/>
                  <a:gd name="T58" fmla="*/ 70 w 140"/>
                  <a:gd name="T59" fmla="*/ 140 h 140"/>
                  <a:gd name="T60" fmla="*/ 140 w 140"/>
                  <a:gd name="T61" fmla="*/ 70 h 140"/>
                  <a:gd name="T62" fmla="*/ 130 w 140"/>
                  <a:gd name="T63" fmla="*/ 34 h 140"/>
                  <a:gd name="T64" fmla="*/ 70 w 140"/>
                  <a:gd name="T65" fmla="*/ 47 h 140"/>
                  <a:gd name="T66" fmla="*/ 80 w 140"/>
                  <a:gd name="T67" fmla="*/ 49 h 140"/>
                  <a:gd name="T68" fmla="*/ 93 w 140"/>
                  <a:gd name="T69" fmla="*/ 37 h 140"/>
                  <a:gd name="T70" fmla="*/ 70 w 140"/>
                  <a:gd name="T71" fmla="*/ 29 h 140"/>
                  <a:gd name="T72" fmla="*/ 29 w 140"/>
                  <a:gd name="T73" fmla="*/ 70 h 140"/>
                  <a:gd name="T74" fmla="*/ 70 w 140"/>
                  <a:gd name="T75" fmla="*/ 111 h 140"/>
                  <a:gd name="T76" fmla="*/ 111 w 140"/>
                  <a:gd name="T77" fmla="*/ 70 h 140"/>
                  <a:gd name="T78" fmla="*/ 104 w 140"/>
                  <a:gd name="T79" fmla="*/ 48 h 140"/>
                  <a:gd name="T80" fmla="*/ 91 w 140"/>
                  <a:gd name="T81" fmla="*/ 61 h 140"/>
                  <a:gd name="T82" fmla="*/ 93 w 140"/>
                  <a:gd name="T83" fmla="*/ 70 h 140"/>
                  <a:gd name="T84" fmla="*/ 70 w 140"/>
                  <a:gd name="T85" fmla="*/ 94 h 140"/>
                  <a:gd name="T86" fmla="*/ 46 w 140"/>
                  <a:gd name="T87" fmla="*/ 70 h 140"/>
                  <a:gd name="T88" fmla="*/ 70 w 140"/>
                  <a:gd name="T89" fmla="*/ 47 h 1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140" h="140">
                    <a:moveTo>
                      <a:pt x="101" y="21"/>
                    </a:moveTo>
                    <a:cubicBezTo>
                      <a:pt x="117" y="5"/>
                      <a:pt x="117" y="5"/>
                      <a:pt x="117" y="5"/>
                    </a:cubicBezTo>
                    <a:cubicBezTo>
                      <a:pt x="118" y="5"/>
                      <a:pt x="118" y="5"/>
                      <a:pt x="119" y="6"/>
                    </a:cubicBezTo>
                    <a:cubicBezTo>
                      <a:pt x="120" y="20"/>
                      <a:pt x="120" y="20"/>
                      <a:pt x="120" y="20"/>
                    </a:cubicBezTo>
                    <a:cubicBezTo>
                      <a:pt x="134" y="22"/>
                      <a:pt x="134" y="22"/>
                      <a:pt x="134" y="22"/>
                    </a:cubicBezTo>
                    <a:cubicBezTo>
                      <a:pt x="136" y="22"/>
                      <a:pt x="136" y="23"/>
                      <a:pt x="135" y="24"/>
                    </a:cubicBezTo>
                    <a:cubicBezTo>
                      <a:pt x="120" y="39"/>
                      <a:pt x="120" y="39"/>
                      <a:pt x="120" y="39"/>
                    </a:cubicBezTo>
                    <a:cubicBezTo>
                      <a:pt x="119" y="40"/>
                      <a:pt x="117" y="40"/>
                      <a:pt x="116" y="40"/>
                    </a:cubicBezTo>
                    <a:cubicBezTo>
                      <a:pt x="107" y="39"/>
                      <a:pt x="107" y="39"/>
                      <a:pt x="107" y="39"/>
                    </a:cubicBezTo>
                    <a:cubicBezTo>
                      <a:pt x="80" y="66"/>
                      <a:pt x="80" y="66"/>
                      <a:pt x="80" y="66"/>
                    </a:cubicBezTo>
                    <a:cubicBezTo>
                      <a:pt x="82" y="70"/>
                      <a:pt x="82" y="75"/>
                      <a:pt x="78" y="79"/>
                    </a:cubicBezTo>
                    <a:cubicBezTo>
                      <a:pt x="73" y="84"/>
                      <a:pt x="66" y="84"/>
                      <a:pt x="61" y="79"/>
                    </a:cubicBezTo>
                    <a:cubicBezTo>
                      <a:pt x="57" y="74"/>
                      <a:pt x="57" y="67"/>
                      <a:pt x="61" y="62"/>
                    </a:cubicBezTo>
                    <a:cubicBezTo>
                      <a:pt x="65" y="59"/>
                      <a:pt x="70" y="58"/>
                      <a:pt x="75" y="60"/>
                    </a:cubicBezTo>
                    <a:cubicBezTo>
                      <a:pt x="101" y="34"/>
                      <a:pt x="101" y="34"/>
                      <a:pt x="101" y="34"/>
                    </a:cubicBezTo>
                    <a:cubicBezTo>
                      <a:pt x="100" y="25"/>
                      <a:pt x="100" y="25"/>
                      <a:pt x="100" y="25"/>
                    </a:cubicBezTo>
                    <a:cubicBezTo>
                      <a:pt x="100" y="23"/>
                      <a:pt x="101" y="22"/>
                      <a:pt x="101" y="21"/>
                    </a:cubicBezTo>
                    <a:close/>
                    <a:moveTo>
                      <a:pt x="130" y="34"/>
                    </a:moveTo>
                    <a:cubicBezTo>
                      <a:pt x="122" y="42"/>
                      <a:pt x="122" y="42"/>
                      <a:pt x="122" y="42"/>
                    </a:cubicBezTo>
                    <a:cubicBezTo>
                      <a:pt x="121" y="43"/>
                      <a:pt x="119" y="44"/>
                      <a:pt x="118" y="44"/>
                    </a:cubicBezTo>
                    <a:cubicBezTo>
                      <a:pt x="122" y="52"/>
                      <a:pt x="124" y="61"/>
                      <a:pt x="124" y="70"/>
                    </a:cubicBezTo>
                    <a:cubicBezTo>
                      <a:pt x="124" y="100"/>
                      <a:pt x="100" y="125"/>
                      <a:pt x="70" y="125"/>
                    </a:cubicBezTo>
                    <a:cubicBezTo>
                      <a:pt x="40" y="125"/>
                      <a:pt x="15" y="100"/>
                      <a:pt x="15" y="70"/>
                    </a:cubicBezTo>
                    <a:cubicBezTo>
                      <a:pt x="15" y="40"/>
                      <a:pt x="40" y="16"/>
                      <a:pt x="70" y="16"/>
                    </a:cubicBezTo>
                    <a:cubicBezTo>
                      <a:pt x="79" y="16"/>
                      <a:pt x="88" y="18"/>
                      <a:pt x="96" y="23"/>
                    </a:cubicBezTo>
                    <a:cubicBezTo>
                      <a:pt x="97" y="21"/>
                      <a:pt x="98" y="19"/>
                      <a:pt x="99" y="18"/>
                    </a:cubicBezTo>
                    <a:cubicBezTo>
                      <a:pt x="106" y="11"/>
                      <a:pt x="106" y="11"/>
                      <a:pt x="106" y="11"/>
                    </a:cubicBezTo>
                    <a:cubicBezTo>
                      <a:pt x="96" y="4"/>
                      <a:pt x="83" y="0"/>
                      <a:pt x="70" y="0"/>
                    </a:cubicBezTo>
                    <a:cubicBezTo>
                      <a:pt x="31" y="0"/>
                      <a:pt x="0" y="32"/>
                      <a:pt x="0" y="70"/>
                    </a:cubicBezTo>
                    <a:cubicBezTo>
                      <a:pt x="0" y="109"/>
                      <a:pt x="31" y="140"/>
                      <a:pt x="70" y="140"/>
                    </a:cubicBezTo>
                    <a:cubicBezTo>
                      <a:pt x="108" y="140"/>
                      <a:pt x="140" y="109"/>
                      <a:pt x="140" y="70"/>
                    </a:cubicBezTo>
                    <a:cubicBezTo>
                      <a:pt x="140" y="57"/>
                      <a:pt x="136" y="45"/>
                      <a:pt x="130" y="34"/>
                    </a:cubicBezTo>
                    <a:close/>
                    <a:moveTo>
                      <a:pt x="70" y="47"/>
                    </a:moveTo>
                    <a:cubicBezTo>
                      <a:pt x="73" y="47"/>
                      <a:pt x="77" y="48"/>
                      <a:pt x="80" y="49"/>
                    </a:cubicBezTo>
                    <a:cubicBezTo>
                      <a:pt x="93" y="37"/>
                      <a:pt x="93" y="37"/>
                      <a:pt x="93" y="37"/>
                    </a:cubicBezTo>
                    <a:cubicBezTo>
                      <a:pt x="86" y="32"/>
                      <a:pt x="78" y="29"/>
                      <a:pt x="70" y="29"/>
                    </a:cubicBezTo>
                    <a:cubicBezTo>
                      <a:pt x="47" y="29"/>
                      <a:pt x="29" y="48"/>
                      <a:pt x="29" y="70"/>
                    </a:cubicBezTo>
                    <a:cubicBezTo>
                      <a:pt x="29" y="93"/>
                      <a:pt x="47" y="111"/>
                      <a:pt x="70" y="111"/>
                    </a:cubicBezTo>
                    <a:cubicBezTo>
                      <a:pt x="92" y="111"/>
                      <a:pt x="111" y="93"/>
                      <a:pt x="111" y="70"/>
                    </a:cubicBezTo>
                    <a:cubicBezTo>
                      <a:pt x="111" y="62"/>
                      <a:pt x="108" y="54"/>
                      <a:pt x="104" y="48"/>
                    </a:cubicBezTo>
                    <a:cubicBezTo>
                      <a:pt x="91" y="61"/>
                      <a:pt x="91" y="61"/>
                      <a:pt x="91" y="61"/>
                    </a:cubicBezTo>
                    <a:cubicBezTo>
                      <a:pt x="92" y="64"/>
                      <a:pt x="93" y="67"/>
                      <a:pt x="93" y="70"/>
                    </a:cubicBezTo>
                    <a:cubicBezTo>
                      <a:pt x="93" y="83"/>
                      <a:pt x="83" y="94"/>
                      <a:pt x="70" y="94"/>
                    </a:cubicBezTo>
                    <a:cubicBezTo>
                      <a:pt x="57" y="94"/>
                      <a:pt x="46" y="83"/>
                      <a:pt x="46" y="70"/>
                    </a:cubicBezTo>
                    <a:cubicBezTo>
                      <a:pt x="46" y="57"/>
                      <a:pt x="57" y="47"/>
                      <a:pt x="70" y="47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4" name="矩形: 圆角 53">
              <a:extLst>
                <a:ext uri="{FF2B5EF4-FFF2-40B4-BE49-F238E27FC236}">
                  <a16:creationId xmlns:a16="http://schemas.microsoft.com/office/drawing/2014/main" id="{43AD1611-25D6-D2B4-A351-A6744EDF151B}"/>
                </a:ext>
              </a:extLst>
            </p:cNvPr>
            <p:cNvSpPr/>
            <p:nvPr/>
          </p:nvSpPr>
          <p:spPr>
            <a:xfrm>
              <a:off x="6748283" y="2963298"/>
              <a:ext cx="984606" cy="583258"/>
            </a:xfrm>
            <a:prstGeom prst="roundRect">
              <a:avLst>
                <a:gd name="adj" fmla="val 50000"/>
              </a:avLst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0" i="0" u="none" strike="noStrike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sk supervision and controller</a:t>
              </a:r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6" name="直接箭头连接符 55">
              <a:extLst>
                <a:ext uri="{FF2B5EF4-FFF2-40B4-BE49-F238E27FC236}">
                  <a16:creationId xmlns:a16="http://schemas.microsoft.com/office/drawing/2014/main" id="{F6DBB6C7-33A4-2028-B4DF-4E4D6666D3C6}"/>
                </a:ext>
              </a:extLst>
            </p:cNvPr>
            <p:cNvCxnSpPr>
              <a:cxnSpLocks/>
              <a:stCxn id="24" idx="6"/>
              <a:endCxn id="54" idx="1"/>
            </p:cNvCxnSpPr>
            <p:nvPr/>
          </p:nvCxnSpPr>
          <p:spPr>
            <a:xfrm>
              <a:off x="6506096" y="3254760"/>
              <a:ext cx="242187" cy="167"/>
            </a:xfrm>
            <a:prstGeom prst="straightConnector1">
              <a:avLst/>
            </a:prstGeom>
            <a:ln>
              <a:solidFill>
                <a:schemeClr val="bg2">
                  <a:lumMod val="50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椭圆 57">
              <a:extLst>
                <a:ext uri="{FF2B5EF4-FFF2-40B4-BE49-F238E27FC236}">
                  <a16:creationId xmlns:a16="http://schemas.microsoft.com/office/drawing/2014/main" id="{9C7668C5-AA69-FC71-6C1B-5BF2E71ECAA7}"/>
                </a:ext>
              </a:extLst>
            </p:cNvPr>
            <p:cNvSpPr/>
            <p:nvPr/>
          </p:nvSpPr>
          <p:spPr>
            <a:xfrm>
              <a:off x="6662453" y="3690587"/>
              <a:ext cx="1070436" cy="493209"/>
            </a:xfrm>
            <a:prstGeom prst="ellipse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000" b="0" i="0" u="none" strike="noStrike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ndition-action rule</a:t>
              </a:r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0" name="连接符: 肘形 59">
              <a:extLst>
                <a:ext uri="{FF2B5EF4-FFF2-40B4-BE49-F238E27FC236}">
                  <a16:creationId xmlns:a16="http://schemas.microsoft.com/office/drawing/2014/main" id="{0D03E95D-D002-F84B-B924-98E433949E60}"/>
                </a:ext>
              </a:extLst>
            </p:cNvPr>
            <p:cNvCxnSpPr>
              <a:cxnSpLocks/>
              <a:stCxn id="58" idx="6"/>
              <a:endCxn id="54" idx="3"/>
            </p:cNvCxnSpPr>
            <p:nvPr/>
          </p:nvCxnSpPr>
          <p:spPr>
            <a:xfrm flipV="1">
              <a:off x="7732889" y="3254927"/>
              <a:ext cx="12700" cy="682265"/>
            </a:xfrm>
            <a:prstGeom prst="bentConnector3">
              <a:avLst>
                <a:gd name="adj1" fmla="val 1800000"/>
              </a:avLst>
            </a:prstGeom>
            <a:ln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CCC15FD2-CFD2-3E93-E7A3-A4B986017ADA}"/>
                </a:ext>
              </a:extLst>
            </p:cNvPr>
            <p:cNvSpPr txBox="1"/>
            <p:nvPr/>
          </p:nvSpPr>
          <p:spPr>
            <a:xfrm>
              <a:off x="4151780" y="1759596"/>
              <a:ext cx="101969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nso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8A60ACE2-2D58-E8C0-1D38-C53DBAF184EF}"/>
                </a:ext>
              </a:extLst>
            </p:cNvPr>
            <p:cNvSpPr txBox="1"/>
            <p:nvPr/>
          </p:nvSpPr>
          <p:spPr>
            <a:xfrm>
              <a:off x="4123291" y="2455259"/>
              <a:ext cx="936978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ssage receive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25D80782-544D-9DC5-A15F-2EAE15BF1767}"/>
                </a:ext>
              </a:extLst>
            </p:cNvPr>
            <p:cNvSpPr txBox="1"/>
            <p:nvPr/>
          </p:nvSpPr>
          <p:spPr>
            <a:xfrm>
              <a:off x="4121733" y="3314686"/>
              <a:ext cx="84070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QML rule bas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27B5F721-530E-FE4B-607F-F164FA07A21F}"/>
                </a:ext>
              </a:extLst>
            </p:cNvPr>
            <p:cNvSpPr txBox="1"/>
            <p:nvPr/>
          </p:nvSpPr>
          <p:spPr>
            <a:xfrm>
              <a:off x="4121733" y="4098888"/>
              <a:ext cx="882126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ssage receive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7BA1D8FD-1405-5092-1F0B-77A349AF1DF8}"/>
                </a:ext>
              </a:extLst>
            </p:cNvPr>
            <p:cNvSpPr txBox="1"/>
            <p:nvPr/>
          </p:nvSpPr>
          <p:spPr>
            <a:xfrm>
              <a:off x="4123291" y="4949985"/>
              <a:ext cx="78096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fecto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588E6962-E6E5-8D53-E1F2-EA22FE80F21F}"/>
                </a:ext>
              </a:extLst>
            </p:cNvPr>
            <p:cNvSpPr txBox="1"/>
            <p:nvPr/>
          </p:nvSpPr>
          <p:spPr>
            <a:xfrm>
              <a:off x="5629853" y="3057101"/>
              <a:ext cx="653636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sk library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1AC6292D-AF4E-97D8-584C-D8E23B329464}"/>
                </a:ext>
              </a:extLst>
            </p:cNvPr>
            <p:cNvSpPr txBox="1"/>
            <p:nvPr/>
          </p:nvSpPr>
          <p:spPr>
            <a:xfrm>
              <a:off x="6571089" y="2332633"/>
              <a:ext cx="110965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idding module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DEDBF292-ED1C-CB0E-22C7-BC7A9F78D00A}"/>
                </a:ext>
              </a:extLst>
            </p:cNvPr>
            <p:cNvSpPr txBox="1"/>
            <p:nvPr/>
          </p:nvSpPr>
          <p:spPr>
            <a:xfrm>
              <a:off x="5491527" y="3720360"/>
              <a:ext cx="704509" cy="553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0" i="0" u="none" strike="noStrike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inning bid module 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94060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37</Words>
  <Application>Microsoft Office PowerPoint</Application>
  <PresentationFormat>宽屏</PresentationFormat>
  <Paragraphs>1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Think</cp:lastModifiedBy>
  <cp:revision>1</cp:revision>
  <dcterms:created xsi:type="dcterms:W3CDTF">2022-10-08T12:01:03Z</dcterms:created>
  <dcterms:modified xsi:type="dcterms:W3CDTF">2022-10-08T12:41:59Z</dcterms:modified>
</cp:coreProperties>
</file>